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7"/>
  </p:notesMasterIdLst>
  <p:sldIdLst>
    <p:sldId id="262" r:id="rId2"/>
    <p:sldId id="257" r:id="rId3"/>
    <p:sldId id="263" r:id="rId4"/>
    <p:sldId id="261" r:id="rId5"/>
    <p:sldId id="264" r:id="rId6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57" userDrawn="1">
          <p15:clr>
            <a:srgbClr val="A4A3A4"/>
          </p15:clr>
        </p15:guide>
        <p15:guide id="2" pos="5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284" autoAdjust="0"/>
    <p:restoredTop sz="95226" autoAdjust="0"/>
  </p:normalViewPr>
  <p:slideViewPr>
    <p:cSldViewPr snapToGrid="0">
      <p:cViewPr>
        <p:scale>
          <a:sx n="80" d="100"/>
          <a:sy n="80" d="100"/>
        </p:scale>
        <p:origin x="2148" y="-84"/>
      </p:cViewPr>
      <p:guideLst>
        <p:guide orient="horz" pos="4957"/>
        <p:guide pos="5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4" Type="http://schemas.openxmlformats.org/officeDocument/2006/relationships/image" Target="../media/image10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image" Target="../media/image11.emf"/><Relationship Id="rId4" Type="http://schemas.openxmlformats.org/officeDocument/2006/relationships/image" Target="../media/image1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3942E-C0A4-4A92-8118-4D267319D377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EBA763-BE69-4DBE-BBBB-170FAD49610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44181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EBA763-BE69-4DBE-BBBB-170FAD496100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16878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EBA763-BE69-4DBE-BBBB-170FAD496100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33996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9207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589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615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4295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1388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1042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5574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5619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8493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5084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2531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34A39-51C8-4B2F-92AD-065270863C02}" type="datetimeFigureOut">
              <a:rPr lang="it-IT" smtClean="0"/>
              <a:t>23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6F590-4939-4E13-9C6B-21C756656AD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6004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10" Type="http://schemas.openxmlformats.org/officeDocument/2006/relationships/image" Target="../media/image10.emf"/><Relationship Id="rId4" Type="http://schemas.openxmlformats.org/officeDocument/2006/relationships/image" Target="../media/image7.emf"/><Relationship Id="rId9" Type="http://schemas.openxmlformats.org/officeDocument/2006/relationships/oleObject" Target="../embeddings/oleObject10.bin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2.bin"/><Relationship Id="rId11" Type="http://schemas.openxmlformats.org/officeDocument/2006/relationships/image" Target="../media/image14.emf"/><Relationship Id="rId5" Type="http://schemas.openxmlformats.org/officeDocument/2006/relationships/image" Target="../media/image11.emf"/><Relationship Id="rId10" Type="http://schemas.openxmlformats.org/officeDocument/2006/relationships/oleObject" Target="../embeddings/oleObject14.bin"/><Relationship Id="rId4" Type="http://schemas.openxmlformats.org/officeDocument/2006/relationships/oleObject" Target="../embeddings/oleObject11.bin"/><Relationship Id="rId9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CasellaDiTesto 111">
            <a:extLst>
              <a:ext uri="{FF2B5EF4-FFF2-40B4-BE49-F238E27FC236}">
                <a16:creationId xmlns="" xmlns:a16="http://schemas.microsoft.com/office/drawing/2014/main" id="{9C50BA3C-F5C9-4141-842F-72B51EA3C4CD}"/>
              </a:ext>
            </a:extLst>
          </p:cNvPr>
          <p:cNvSpPr txBox="1"/>
          <p:nvPr/>
        </p:nvSpPr>
        <p:spPr>
          <a:xfrm>
            <a:off x="2299141" y="242654"/>
            <a:ext cx="2036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</a:p>
        </p:txBody>
      </p:sp>
      <p:grpSp>
        <p:nvGrpSpPr>
          <p:cNvPr id="195" name="Gruppo 194"/>
          <p:cNvGrpSpPr/>
          <p:nvPr/>
        </p:nvGrpSpPr>
        <p:grpSpPr>
          <a:xfrm>
            <a:off x="1059767" y="835286"/>
            <a:ext cx="4880268" cy="7133884"/>
            <a:chOff x="1671832" y="728655"/>
            <a:chExt cx="4880268" cy="7133884"/>
          </a:xfrm>
        </p:grpSpPr>
        <p:grpSp>
          <p:nvGrpSpPr>
            <p:cNvPr id="37" name="Gruppo 36"/>
            <p:cNvGrpSpPr/>
            <p:nvPr/>
          </p:nvGrpSpPr>
          <p:grpSpPr>
            <a:xfrm>
              <a:off x="2775455" y="1051182"/>
              <a:ext cx="3333277" cy="297929"/>
              <a:chOff x="2139458" y="662499"/>
              <a:chExt cx="3634017" cy="324805"/>
            </a:xfrm>
          </p:grpSpPr>
          <p:grpSp>
            <p:nvGrpSpPr>
              <p:cNvPr id="38" name="Gruppo 37"/>
              <p:cNvGrpSpPr/>
              <p:nvPr/>
            </p:nvGrpSpPr>
            <p:grpSpPr>
              <a:xfrm>
                <a:off x="4569459" y="836312"/>
                <a:ext cx="1192061" cy="150992"/>
                <a:chOff x="4618224" y="-5632531"/>
                <a:chExt cx="1311269" cy="150992"/>
              </a:xfrm>
            </p:grpSpPr>
            <p:sp>
              <p:nvSpPr>
                <p:cNvPr id="50" name="Rectangle 325">
                  <a:extLst>
                    <a:ext uri="{FF2B5EF4-FFF2-40B4-BE49-F238E27FC236}">
                      <a16:creationId xmlns="" xmlns:a16="http://schemas.microsoft.com/office/drawing/2014/main" id="{705AC08D-4001-43F4-817C-ADD86243A4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18224" y="-5607037"/>
                  <a:ext cx="211835" cy="111126"/>
                </a:xfrm>
                <a:prstGeom prst="rect">
                  <a:avLst/>
                </a:prstGeom>
                <a:solidFill>
                  <a:srgbClr val="9F044D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83873" tIns="41936" rIns="83873" bIns="41936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537"/>
                </a:p>
              </p:txBody>
            </p:sp>
            <p:grpSp>
              <p:nvGrpSpPr>
                <p:cNvPr id="51" name="Gruppo 50"/>
                <p:cNvGrpSpPr/>
                <p:nvPr/>
              </p:nvGrpSpPr>
              <p:grpSpPr>
                <a:xfrm>
                  <a:off x="4622133" y="-5632531"/>
                  <a:ext cx="1307360" cy="150992"/>
                  <a:chOff x="4622133" y="-5632531"/>
                  <a:chExt cx="1307360" cy="150992"/>
                </a:xfrm>
              </p:grpSpPr>
              <p:sp>
                <p:nvSpPr>
                  <p:cNvPr id="52" name="Rectangle 324">
                    <a:extLst>
                      <a:ext uri="{FF2B5EF4-FFF2-40B4-BE49-F238E27FC236}">
                        <a16:creationId xmlns="" xmlns:a16="http://schemas.microsoft.com/office/drawing/2014/main" id="{E3861ED7-705C-4412-A8E6-78A77457C5B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904855" y="-5632531"/>
                    <a:ext cx="1024638" cy="15099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838688"/>
                    <a:r>
                      <a:rPr lang="it-IT" altLang="it-IT" sz="9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+LPS </a:t>
                    </a:r>
                    <a:r>
                      <a:rPr lang="it-IT" altLang="it-IT" sz="900" dirty="0" err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ed</a:t>
                    </a:r>
                    <a:r>
                      <a:rPr lang="it-IT" altLang="it-IT" sz="9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r>
                      <a:rPr lang="it-IT" altLang="it-IT" sz="900" dirty="0" err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emale</a:t>
                    </a:r>
                    <a:endParaRPr lang="it-IT" altLang="it-IT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3" name="Freeform 326">
                    <a:extLst>
                      <a:ext uri="{FF2B5EF4-FFF2-40B4-BE49-F238E27FC236}">
                        <a16:creationId xmlns="" xmlns:a16="http://schemas.microsoft.com/office/drawing/2014/main" id="{0EABA3A6-898F-4D7B-A403-33F9F4898A1C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4622133" y="-5605569"/>
                    <a:ext cx="193675" cy="108238"/>
                  </a:xfrm>
                  <a:custGeom>
                    <a:avLst/>
                    <a:gdLst>
                      <a:gd name="T0" fmla="*/ 18 w 122"/>
                      <a:gd name="T1" fmla="*/ 0 h 75"/>
                      <a:gd name="T2" fmla="*/ 12 w 122"/>
                      <a:gd name="T3" fmla="*/ 6 h 75"/>
                      <a:gd name="T4" fmla="*/ 35 w 122"/>
                      <a:gd name="T5" fmla="*/ 0 h 75"/>
                      <a:gd name="T6" fmla="*/ 41 w 122"/>
                      <a:gd name="T7" fmla="*/ 6 h 75"/>
                      <a:gd name="T8" fmla="*/ 35 w 122"/>
                      <a:gd name="T9" fmla="*/ 0 h 75"/>
                      <a:gd name="T10" fmla="*/ 64 w 122"/>
                      <a:gd name="T11" fmla="*/ 0 h 75"/>
                      <a:gd name="T12" fmla="*/ 58 w 122"/>
                      <a:gd name="T13" fmla="*/ 6 h 75"/>
                      <a:gd name="T14" fmla="*/ 81 w 122"/>
                      <a:gd name="T15" fmla="*/ 0 h 75"/>
                      <a:gd name="T16" fmla="*/ 87 w 122"/>
                      <a:gd name="T17" fmla="*/ 6 h 75"/>
                      <a:gd name="T18" fmla="*/ 81 w 122"/>
                      <a:gd name="T19" fmla="*/ 0 h 75"/>
                      <a:gd name="T20" fmla="*/ 110 w 122"/>
                      <a:gd name="T21" fmla="*/ 0 h 75"/>
                      <a:gd name="T22" fmla="*/ 105 w 122"/>
                      <a:gd name="T23" fmla="*/ 6 h 75"/>
                      <a:gd name="T24" fmla="*/ 0 w 122"/>
                      <a:gd name="T25" fmla="*/ 23 h 75"/>
                      <a:gd name="T26" fmla="*/ 6 w 122"/>
                      <a:gd name="T27" fmla="*/ 29 h 75"/>
                      <a:gd name="T28" fmla="*/ 0 w 122"/>
                      <a:gd name="T29" fmla="*/ 23 h 75"/>
                      <a:gd name="T30" fmla="*/ 29 w 122"/>
                      <a:gd name="T31" fmla="*/ 23 h 75"/>
                      <a:gd name="T32" fmla="*/ 24 w 122"/>
                      <a:gd name="T33" fmla="*/ 29 h 75"/>
                      <a:gd name="T34" fmla="*/ 47 w 122"/>
                      <a:gd name="T35" fmla="*/ 23 h 75"/>
                      <a:gd name="T36" fmla="*/ 53 w 122"/>
                      <a:gd name="T37" fmla="*/ 29 h 75"/>
                      <a:gd name="T38" fmla="*/ 47 w 122"/>
                      <a:gd name="T39" fmla="*/ 23 h 75"/>
                      <a:gd name="T40" fmla="*/ 76 w 122"/>
                      <a:gd name="T41" fmla="*/ 23 h 75"/>
                      <a:gd name="T42" fmla="*/ 70 w 122"/>
                      <a:gd name="T43" fmla="*/ 29 h 75"/>
                      <a:gd name="T44" fmla="*/ 93 w 122"/>
                      <a:gd name="T45" fmla="*/ 23 h 75"/>
                      <a:gd name="T46" fmla="*/ 99 w 122"/>
                      <a:gd name="T47" fmla="*/ 29 h 75"/>
                      <a:gd name="T48" fmla="*/ 93 w 122"/>
                      <a:gd name="T49" fmla="*/ 23 h 75"/>
                      <a:gd name="T50" fmla="*/ 122 w 122"/>
                      <a:gd name="T51" fmla="*/ 23 h 75"/>
                      <a:gd name="T52" fmla="*/ 116 w 122"/>
                      <a:gd name="T53" fmla="*/ 29 h 75"/>
                      <a:gd name="T54" fmla="*/ 12 w 122"/>
                      <a:gd name="T55" fmla="*/ 46 h 75"/>
                      <a:gd name="T56" fmla="*/ 18 w 122"/>
                      <a:gd name="T57" fmla="*/ 52 h 75"/>
                      <a:gd name="T58" fmla="*/ 12 w 122"/>
                      <a:gd name="T59" fmla="*/ 46 h 75"/>
                      <a:gd name="T60" fmla="*/ 41 w 122"/>
                      <a:gd name="T61" fmla="*/ 46 h 75"/>
                      <a:gd name="T62" fmla="*/ 35 w 122"/>
                      <a:gd name="T63" fmla="*/ 52 h 75"/>
                      <a:gd name="T64" fmla="*/ 58 w 122"/>
                      <a:gd name="T65" fmla="*/ 46 h 75"/>
                      <a:gd name="T66" fmla="*/ 64 w 122"/>
                      <a:gd name="T67" fmla="*/ 52 h 75"/>
                      <a:gd name="T68" fmla="*/ 58 w 122"/>
                      <a:gd name="T69" fmla="*/ 46 h 75"/>
                      <a:gd name="T70" fmla="*/ 87 w 122"/>
                      <a:gd name="T71" fmla="*/ 46 h 75"/>
                      <a:gd name="T72" fmla="*/ 81 w 122"/>
                      <a:gd name="T73" fmla="*/ 52 h 75"/>
                      <a:gd name="T74" fmla="*/ 105 w 122"/>
                      <a:gd name="T75" fmla="*/ 46 h 75"/>
                      <a:gd name="T76" fmla="*/ 110 w 122"/>
                      <a:gd name="T77" fmla="*/ 52 h 75"/>
                      <a:gd name="T78" fmla="*/ 105 w 122"/>
                      <a:gd name="T79" fmla="*/ 46 h 75"/>
                      <a:gd name="T80" fmla="*/ 6 w 122"/>
                      <a:gd name="T81" fmla="*/ 69 h 75"/>
                      <a:gd name="T82" fmla="*/ 0 w 122"/>
                      <a:gd name="T83" fmla="*/ 75 h 75"/>
                      <a:gd name="T84" fmla="*/ 24 w 122"/>
                      <a:gd name="T85" fmla="*/ 69 h 75"/>
                      <a:gd name="T86" fmla="*/ 29 w 122"/>
                      <a:gd name="T87" fmla="*/ 75 h 75"/>
                      <a:gd name="T88" fmla="*/ 24 w 122"/>
                      <a:gd name="T89" fmla="*/ 69 h 75"/>
                      <a:gd name="T90" fmla="*/ 53 w 122"/>
                      <a:gd name="T91" fmla="*/ 69 h 75"/>
                      <a:gd name="T92" fmla="*/ 47 w 122"/>
                      <a:gd name="T93" fmla="*/ 75 h 75"/>
                      <a:gd name="T94" fmla="*/ 70 w 122"/>
                      <a:gd name="T95" fmla="*/ 69 h 75"/>
                      <a:gd name="T96" fmla="*/ 76 w 122"/>
                      <a:gd name="T97" fmla="*/ 75 h 75"/>
                      <a:gd name="T98" fmla="*/ 70 w 122"/>
                      <a:gd name="T99" fmla="*/ 69 h 75"/>
                      <a:gd name="T100" fmla="*/ 99 w 122"/>
                      <a:gd name="T101" fmla="*/ 69 h 75"/>
                      <a:gd name="T102" fmla="*/ 93 w 122"/>
                      <a:gd name="T103" fmla="*/ 75 h 75"/>
                      <a:gd name="T104" fmla="*/ 116 w 122"/>
                      <a:gd name="T105" fmla="*/ 69 h 75"/>
                      <a:gd name="T106" fmla="*/ 122 w 122"/>
                      <a:gd name="T107" fmla="*/ 75 h 75"/>
                      <a:gd name="T108" fmla="*/ 116 w 122"/>
                      <a:gd name="T109" fmla="*/ 69 h 7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  <a:cxn ang="0">
                        <a:pos x="T68" y="T69"/>
                      </a:cxn>
                      <a:cxn ang="0">
                        <a:pos x="T70" y="T71"/>
                      </a:cxn>
                      <a:cxn ang="0">
                        <a:pos x="T72" y="T73"/>
                      </a:cxn>
                      <a:cxn ang="0">
                        <a:pos x="T74" y="T75"/>
                      </a:cxn>
                      <a:cxn ang="0">
                        <a:pos x="T76" y="T77"/>
                      </a:cxn>
                      <a:cxn ang="0">
                        <a:pos x="T78" y="T79"/>
                      </a:cxn>
                      <a:cxn ang="0">
                        <a:pos x="T80" y="T81"/>
                      </a:cxn>
                      <a:cxn ang="0">
                        <a:pos x="T82" y="T83"/>
                      </a:cxn>
                      <a:cxn ang="0">
                        <a:pos x="T84" y="T85"/>
                      </a:cxn>
                      <a:cxn ang="0">
                        <a:pos x="T86" y="T87"/>
                      </a:cxn>
                      <a:cxn ang="0">
                        <a:pos x="T88" y="T89"/>
                      </a:cxn>
                      <a:cxn ang="0">
                        <a:pos x="T90" y="T91"/>
                      </a:cxn>
                      <a:cxn ang="0">
                        <a:pos x="T92" y="T93"/>
                      </a:cxn>
                      <a:cxn ang="0">
                        <a:pos x="T94" y="T95"/>
                      </a:cxn>
                      <a:cxn ang="0">
                        <a:pos x="T96" y="T97"/>
                      </a:cxn>
                      <a:cxn ang="0">
                        <a:pos x="T98" y="T99"/>
                      </a:cxn>
                      <a:cxn ang="0">
                        <a:pos x="T100" y="T101"/>
                      </a:cxn>
                      <a:cxn ang="0">
                        <a:pos x="T102" y="T103"/>
                      </a:cxn>
                      <a:cxn ang="0">
                        <a:pos x="T104" y="T105"/>
                      </a:cxn>
                      <a:cxn ang="0">
                        <a:pos x="T106" y="T107"/>
                      </a:cxn>
                      <a:cxn ang="0">
                        <a:pos x="T108" y="T109"/>
                      </a:cxn>
                    </a:cxnLst>
                    <a:rect l="0" t="0" r="r" b="b"/>
                    <a:pathLst>
                      <a:path w="122" h="75">
                        <a:moveTo>
                          <a:pt x="12" y="0"/>
                        </a:moveTo>
                        <a:lnTo>
                          <a:pt x="18" y="0"/>
                        </a:lnTo>
                        <a:lnTo>
                          <a:pt x="18" y="6"/>
                        </a:lnTo>
                        <a:lnTo>
                          <a:pt x="12" y="6"/>
                        </a:lnTo>
                        <a:lnTo>
                          <a:pt x="12" y="0"/>
                        </a:lnTo>
                        <a:close/>
                        <a:moveTo>
                          <a:pt x="35" y="0"/>
                        </a:moveTo>
                        <a:lnTo>
                          <a:pt x="41" y="0"/>
                        </a:lnTo>
                        <a:lnTo>
                          <a:pt x="41" y="6"/>
                        </a:lnTo>
                        <a:lnTo>
                          <a:pt x="35" y="6"/>
                        </a:lnTo>
                        <a:lnTo>
                          <a:pt x="35" y="0"/>
                        </a:lnTo>
                        <a:close/>
                        <a:moveTo>
                          <a:pt x="58" y="0"/>
                        </a:moveTo>
                        <a:lnTo>
                          <a:pt x="64" y="0"/>
                        </a:lnTo>
                        <a:lnTo>
                          <a:pt x="64" y="6"/>
                        </a:lnTo>
                        <a:lnTo>
                          <a:pt x="58" y="6"/>
                        </a:lnTo>
                        <a:lnTo>
                          <a:pt x="58" y="0"/>
                        </a:lnTo>
                        <a:close/>
                        <a:moveTo>
                          <a:pt x="81" y="0"/>
                        </a:moveTo>
                        <a:lnTo>
                          <a:pt x="87" y="0"/>
                        </a:lnTo>
                        <a:lnTo>
                          <a:pt x="87" y="6"/>
                        </a:lnTo>
                        <a:lnTo>
                          <a:pt x="81" y="6"/>
                        </a:lnTo>
                        <a:lnTo>
                          <a:pt x="81" y="0"/>
                        </a:lnTo>
                        <a:close/>
                        <a:moveTo>
                          <a:pt x="105" y="0"/>
                        </a:moveTo>
                        <a:lnTo>
                          <a:pt x="110" y="0"/>
                        </a:lnTo>
                        <a:lnTo>
                          <a:pt x="110" y="6"/>
                        </a:lnTo>
                        <a:lnTo>
                          <a:pt x="105" y="6"/>
                        </a:lnTo>
                        <a:lnTo>
                          <a:pt x="105" y="0"/>
                        </a:lnTo>
                        <a:close/>
                        <a:moveTo>
                          <a:pt x="0" y="23"/>
                        </a:moveTo>
                        <a:lnTo>
                          <a:pt x="6" y="23"/>
                        </a:lnTo>
                        <a:lnTo>
                          <a:pt x="6" y="29"/>
                        </a:lnTo>
                        <a:lnTo>
                          <a:pt x="0" y="29"/>
                        </a:lnTo>
                        <a:lnTo>
                          <a:pt x="0" y="23"/>
                        </a:lnTo>
                        <a:close/>
                        <a:moveTo>
                          <a:pt x="24" y="23"/>
                        </a:moveTo>
                        <a:lnTo>
                          <a:pt x="29" y="23"/>
                        </a:lnTo>
                        <a:lnTo>
                          <a:pt x="29" y="29"/>
                        </a:lnTo>
                        <a:lnTo>
                          <a:pt x="24" y="29"/>
                        </a:lnTo>
                        <a:lnTo>
                          <a:pt x="24" y="23"/>
                        </a:lnTo>
                        <a:close/>
                        <a:moveTo>
                          <a:pt x="47" y="23"/>
                        </a:moveTo>
                        <a:lnTo>
                          <a:pt x="53" y="23"/>
                        </a:lnTo>
                        <a:lnTo>
                          <a:pt x="53" y="29"/>
                        </a:lnTo>
                        <a:lnTo>
                          <a:pt x="47" y="29"/>
                        </a:lnTo>
                        <a:lnTo>
                          <a:pt x="47" y="23"/>
                        </a:lnTo>
                        <a:close/>
                        <a:moveTo>
                          <a:pt x="70" y="23"/>
                        </a:moveTo>
                        <a:lnTo>
                          <a:pt x="76" y="23"/>
                        </a:lnTo>
                        <a:lnTo>
                          <a:pt x="76" y="29"/>
                        </a:lnTo>
                        <a:lnTo>
                          <a:pt x="70" y="29"/>
                        </a:lnTo>
                        <a:lnTo>
                          <a:pt x="70" y="23"/>
                        </a:lnTo>
                        <a:close/>
                        <a:moveTo>
                          <a:pt x="93" y="23"/>
                        </a:moveTo>
                        <a:lnTo>
                          <a:pt x="99" y="23"/>
                        </a:lnTo>
                        <a:lnTo>
                          <a:pt x="99" y="29"/>
                        </a:lnTo>
                        <a:lnTo>
                          <a:pt x="93" y="29"/>
                        </a:lnTo>
                        <a:lnTo>
                          <a:pt x="93" y="23"/>
                        </a:lnTo>
                        <a:close/>
                        <a:moveTo>
                          <a:pt x="116" y="23"/>
                        </a:moveTo>
                        <a:lnTo>
                          <a:pt x="122" y="23"/>
                        </a:lnTo>
                        <a:lnTo>
                          <a:pt x="122" y="29"/>
                        </a:lnTo>
                        <a:lnTo>
                          <a:pt x="116" y="29"/>
                        </a:lnTo>
                        <a:lnTo>
                          <a:pt x="116" y="23"/>
                        </a:lnTo>
                        <a:close/>
                        <a:moveTo>
                          <a:pt x="12" y="46"/>
                        </a:moveTo>
                        <a:lnTo>
                          <a:pt x="18" y="46"/>
                        </a:lnTo>
                        <a:lnTo>
                          <a:pt x="18" y="52"/>
                        </a:lnTo>
                        <a:lnTo>
                          <a:pt x="12" y="52"/>
                        </a:lnTo>
                        <a:lnTo>
                          <a:pt x="12" y="46"/>
                        </a:lnTo>
                        <a:close/>
                        <a:moveTo>
                          <a:pt x="35" y="46"/>
                        </a:moveTo>
                        <a:lnTo>
                          <a:pt x="41" y="46"/>
                        </a:lnTo>
                        <a:lnTo>
                          <a:pt x="41" y="52"/>
                        </a:lnTo>
                        <a:lnTo>
                          <a:pt x="35" y="52"/>
                        </a:lnTo>
                        <a:lnTo>
                          <a:pt x="35" y="46"/>
                        </a:lnTo>
                        <a:close/>
                        <a:moveTo>
                          <a:pt x="58" y="46"/>
                        </a:moveTo>
                        <a:lnTo>
                          <a:pt x="64" y="46"/>
                        </a:lnTo>
                        <a:lnTo>
                          <a:pt x="64" y="52"/>
                        </a:lnTo>
                        <a:lnTo>
                          <a:pt x="58" y="52"/>
                        </a:lnTo>
                        <a:lnTo>
                          <a:pt x="58" y="46"/>
                        </a:lnTo>
                        <a:close/>
                        <a:moveTo>
                          <a:pt x="81" y="46"/>
                        </a:moveTo>
                        <a:lnTo>
                          <a:pt x="87" y="46"/>
                        </a:lnTo>
                        <a:lnTo>
                          <a:pt x="87" y="52"/>
                        </a:lnTo>
                        <a:lnTo>
                          <a:pt x="81" y="52"/>
                        </a:lnTo>
                        <a:lnTo>
                          <a:pt x="81" y="46"/>
                        </a:lnTo>
                        <a:close/>
                        <a:moveTo>
                          <a:pt x="105" y="46"/>
                        </a:moveTo>
                        <a:lnTo>
                          <a:pt x="110" y="46"/>
                        </a:lnTo>
                        <a:lnTo>
                          <a:pt x="110" y="52"/>
                        </a:lnTo>
                        <a:lnTo>
                          <a:pt x="105" y="52"/>
                        </a:lnTo>
                        <a:lnTo>
                          <a:pt x="105" y="46"/>
                        </a:lnTo>
                        <a:close/>
                        <a:moveTo>
                          <a:pt x="0" y="69"/>
                        </a:moveTo>
                        <a:lnTo>
                          <a:pt x="6" y="69"/>
                        </a:lnTo>
                        <a:lnTo>
                          <a:pt x="6" y="75"/>
                        </a:lnTo>
                        <a:lnTo>
                          <a:pt x="0" y="75"/>
                        </a:lnTo>
                        <a:lnTo>
                          <a:pt x="0" y="69"/>
                        </a:lnTo>
                        <a:close/>
                        <a:moveTo>
                          <a:pt x="24" y="69"/>
                        </a:moveTo>
                        <a:lnTo>
                          <a:pt x="29" y="69"/>
                        </a:lnTo>
                        <a:lnTo>
                          <a:pt x="29" y="75"/>
                        </a:lnTo>
                        <a:lnTo>
                          <a:pt x="24" y="75"/>
                        </a:lnTo>
                        <a:lnTo>
                          <a:pt x="24" y="69"/>
                        </a:lnTo>
                        <a:close/>
                        <a:moveTo>
                          <a:pt x="47" y="69"/>
                        </a:moveTo>
                        <a:lnTo>
                          <a:pt x="53" y="69"/>
                        </a:lnTo>
                        <a:lnTo>
                          <a:pt x="53" y="75"/>
                        </a:lnTo>
                        <a:lnTo>
                          <a:pt x="47" y="75"/>
                        </a:lnTo>
                        <a:lnTo>
                          <a:pt x="47" y="69"/>
                        </a:lnTo>
                        <a:close/>
                        <a:moveTo>
                          <a:pt x="70" y="69"/>
                        </a:moveTo>
                        <a:lnTo>
                          <a:pt x="76" y="69"/>
                        </a:lnTo>
                        <a:lnTo>
                          <a:pt x="76" y="75"/>
                        </a:lnTo>
                        <a:lnTo>
                          <a:pt x="70" y="75"/>
                        </a:lnTo>
                        <a:lnTo>
                          <a:pt x="70" y="69"/>
                        </a:lnTo>
                        <a:close/>
                        <a:moveTo>
                          <a:pt x="93" y="69"/>
                        </a:moveTo>
                        <a:lnTo>
                          <a:pt x="99" y="69"/>
                        </a:lnTo>
                        <a:lnTo>
                          <a:pt x="99" y="75"/>
                        </a:lnTo>
                        <a:lnTo>
                          <a:pt x="93" y="75"/>
                        </a:lnTo>
                        <a:lnTo>
                          <a:pt x="93" y="69"/>
                        </a:lnTo>
                        <a:close/>
                        <a:moveTo>
                          <a:pt x="116" y="69"/>
                        </a:moveTo>
                        <a:lnTo>
                          <a:pt x="122" y="69"/>
                        </a:lnTo>
                        <a:lnTo>
                          <a:pt x="122" y="75"/>
                        </a:lnTo>
                        <a:lnTo>
                          <a:pt x="116" y="75"/>
                        </a:lnTo>
                        <a:lnTo>
                          <a:pt x="116" y="69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83873" tIns="41936" rIns="83873" bIns="41936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 sz="1537"/>
                  </a:p>
                </p:txBody>
              </p:sp>
            </p:grpSp>
          </p:grpSp>
          <p:grpSp>
            <p:nvGrpSpPr>
              <p:cNvPr id="39" name="Gruppo 38"/>
              <p:cNvGrpSpPr/>
              <p:nvPr/>
            </p:nvGrpSpPr>
            <p:grpSpPr>
              <a:xfrm>
                <a:off x="2139458" y="836080"/>
                <a:ext cx="1109417" cy="150993"/>
                <a:chOff x="2143812" y="-5890018"/>
                <a:chExt cx="1109417" cy="150993"/>
              </a:xfrm>
            </p:grpSpPr>
            <p:sp>
              <p:nvSpPr>
                <p:cNvPr id="46" name="Rectangle 327">
                  <a:extLst>
                    <a:ext uri="{FF2B5EF4-FFF2-40B4-BE49-F238E27FC236}">
                      <a16:creationId xmlns="" xmlns:a16="http://schemas.microsoft.com/office/drawing/2014/main" id="{DDF2A6FF-894F-4EB0-AC24-9C0BC95351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43812" y="-5858890"/>
                  <a:ext cx="196850" cy="107949"/>
                </a:xfrm>
                <a:prstGeom prst="rect">
                  <a:avLst/>
                </a:prstGeom>
                <a:solidFill>
                  <a:srgbClr val="034E6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83873" tIns="41936" rIns="83873" bIns="41936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400"/>
                </a:p>
              </p:txBody>
            </p:sp>
            <p:grpSp>
              <p:nvGrpSpPr>
                <p:cNvPr id="47" name="Gruppo 46"/>
                <p:cNvGrpSpPr/>
                <p:nvPr/>
              </p:nvGrpSpPr>
              <p:grpSpPr>
                <a:xfrm>
                  <a:off x="2145548" y="-5890018"/>
                  <a:ext cx="1107681" cy="150993"/>
                  <a:chOff x="2145548" y="-5890018"/>
                  <a:chExt cx="1107681" cy="150993"/>
                </a:xfrm>
              </p:grpSpPr>
              <p:sp>
                <p:nvSpPr>
                  <p:cNvPr id="48" name="Rectangle 323">
                    <a:extLst>
                      <a:ext uri="{FF2B5EF4-FFF2-40B4-BE49-F238E27FC236}">
                        <a16:creationId xmlns="" xmlns:a16="http://schemas.microsoft.com/office/drawing/2014/main" id="{0778BE42-AD9D-4ABC-B2A3-F97B0D5DAB1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419607" y="-5890018"/>
                    <a:ext cx="833622" cy="1509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838688"/>
                    <a:r>
                      <a:rPr lang="it-IT" altLang="it-IT" sz="9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+LPS </a:t>
                    </a:r>
                    <a:r>
                      <a:rPr lang="it-IT" altLang="it-IT" sz="900" dirty="0" err="1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ed</a:t>
                    </a:r>
                    <a:r>
                      <a:rPr lang="it-IT" altLang="it-IT" sz="9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male</a:t>
                    </a:r>
                    <a:endParaRPr lang="it-IT" altLang="it-IT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9" name="Freeform 328">
                    <a:extLst>
                      <a:ext uri="{FF2B5EF4-FFF2-40B4-BE49-F238E27FC236}">
                        <a16:creationId xmlns="" xmlns:a16="http://schemas.microsoft.com/office/drawing/2014/main" id="{D215320D-57E2-4ED1-9275-235F405C3840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2145548" y="-5847549"/>
                    <a:ext cx="193675" cy="82549"/>
                  </a:xfrm>
                  <a:custGeom>
                    <a:avLst/>
                    <a:gdLst>
                      <a:gd name="T0" fmla="*/ 18 w 122"/>
                      <a:gd name="T1" fmla="*/ 0 h 52"/>
                      <a:gd name="T2" fmla="*/ 12 w 122"/>
                      <a:gd name="T3" fmla="*/ 6 h 52"/>
                      <a:gd name="T4" fmla="*/ 35 w 122"/>
                      <a:gd name="T5" fmla="*/ 0 h 52"/>
                      <a:gd name="T6" fmla="*/ 41 w 122"/>
                      <a:gd name="T7" fmla="*/ 6 h 52"/>
                      <a:gd name="T8" fmla="*/ 35 w 122"/>
                      <a:gd name="T9" fmla="*/ 0 h 52"/>
                      <a:gd name="T10" fmla="*/ 64 w 122"/>
                      <a:gd name="T11" fmla="*/ 0 h 52"/>
                      <a:gd name="T12" fmla="*/ 58 w 122"/>
                      <a:gd name="T13" fmla="*/ 6 h 52"/>
                      <a:gd name="T14" fmla="*/ 81 w 122"/>
                      <a:gd name="T15" fmla="*/ 0 h 52"/>
                      <a:gd name="T16" fmla="*/ 87 w 122"/>
                      <a:gd name="T17" fmla="*/ 6 h 52"/>
                      <a:gd name="T18" fmla="*/ 81 w 122"/>
                      <a:gd name="T19" fmla="*/ 0 h 52"/>
                      <a:gd name="T20" fmla="*/ 110 w 122"/>
                      <a:gd name="T21" fmla="*/ 0 h 52"/>
                      <a:gd name="T22" fmla="*/ 105 w 122"/>
                      <a:gd name="T23" fmla="*/ 6 h 52"/>
                      <a:gd name="T24" fmla="*/ 0 w 122"/>
                      <a:gd name="T25" fmla="*/ 23 h 52"/>
                      <a:gd name="T26" fmla="*/ 6 w 122"/>
                      <a:gd name="T27" fmla="*/ 29 h 52"/>
                      <a:gd name="T28" fmla="*/ 0 w 122"/>
                      <a:gd name="T29" fmla="*/ 23 h 52"/>
                      <a:gd name="T30" fmla="*/ 29 w 122"/>
                      <a:gd name="T31" fmla="*/ 23 h 52"/>
                      <a:gd name="T32" fmla="*/ 24 w 122"/>
                      <a:gd name="T33" fmla="*/ 29 h 52"/>
                      <a:gd name="T34" fmla="*/ 47 w 122"/>
                      <a:gd name="T35" fmla="*/ 23 h 52"/>
                      <a:gd name="T36" fmla="*/ 53 w 122"/>
                      <a:gd name="T37" fmla="*/ 29 h 52"/>
                      <a:gd name="T38" fmla="*/ 47 w 122"/>
                      <a:gd name="T39" fmla="*/ 23 h 52"/>
                      <a:gd name="T40" fmla="*/ 76 w 122"/>
                      <a:gd name="T41" fmla="*/ 23 h 52"/>
                      <a:gd name="T42" fmla="*/ 70 w 122"/>
                      <a:gd name="T43" fmla="*/ 29 h 52"/>
                      <a:gd name="T44" fmla="*/ 93 w 122"/>
                      <a:gd name="T45" fmla="*/ 23 h 52"/>
                      <a:gd name="T46" fmla="*/ 99 w 122"/>
                      <a:gd name="T47" fmla="*/ 29 h 52"/>
                      <a:gd name="T48" fmla="*/ 93 w 122"/>
                      <a:gd name="T49" fmla="*/ 23 h 52"/>
                      <a:gd name="T50" fmla="*/ 122 w 122"/>
                      <a:gd name="T51" fmla="*/ 23 h 52"/>
                      <a:gd name="T52" fmla="*/ 116 w 122"/>
                      <a:gd name="T53" fmla="*/ 29 h 52"/>
                      <a:gd name="T54" fmla="*/ 12 w 122"/>
                      <a:gd name="T55" fmla="*/ 46 h 52"/>
                      <a:gd name="T56" fmla="*/ 18 w 122"/>
                      <a:gd name="T57" fmla="*/ 52 h 52"/>
                      <a:gd name="T58" fmla="*/ 12 w 122"/>
                      <a:gd name="T59" fmla="*/ 46 h 52"/>
                      <a:gd name="T60" fmla="*/ 41 w 122"/>
                      <a:gd name="T61" fmla="*/ 46 h 52"/>
                      <a:gd name="T62" fmla="*/ 35 w 122"/>
                      <a:gd name="T63" fmla="*/ 52 h 52"/>
                      <a:gd name="T64" fmla="*/ 58 w 122"/>
                      <a:gd name="T65" fmla="*/ 46 h 52"/>
                      <a:gd name="T66" fmla="*/ 64 w 122"/>
                      <a:gd name="T67" fmla="*/ 52 h 52"/>
                      <a:gd name="T68" fmla="*/ 58 w 122"/>
                      <a:gd name="T69" fmla="*/ 46 h 52"/>
                      <a:gd name="T70" fmla="*/ 87 w 122"/>
                      <a:gd name="T71" fmla="*/ 46 h 52"/>
                      <a:gd name="T72" fmla="*/ 81 w 122"/>
                      <a:gd name="T73" fmla="*/ 52 h 52"/>
                      <a:gd name="T74" fmla="*/ 105 w 122"/>
                      <a:gd name="T75" fmla="*/ 46 h 52"/>
                      <a:gd name="T76" fmla="*/ 110 w 122"/>
                      <a:gd name="T77" fmla="*/ 52 h 52"/>
                      <a:gd name="T78" fmla="*/ 105 w 122"/>
                      <a:gd name="T79" fmla="*/ 46 h 5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  <a:cxn ang="0">
                        <a:pos x="T68" y="T69"/>
                      </a:cxn>
                      <a:cxn ang="0">
                        <a:pos x="T70" y="T71"/>
                      </a:cxn>
                      <a:cxn ang="0">
                        <a:pos x="T72" y="T73"/>
                      </a:cxn>
                      <a:cxn ang="0">
                        <a:pos x="T74" y="T75"/>
                      </a:cxn>
                      <a:cxn ang="0">
                        <a:pos x="T76" y="T77"/>
                      </a:cxn>
                      <a:cxn ang="0">
                        <a:pos x="T78" y="T79"/>
                      </a:cxn>
                    </a:cxnLst>
                    <a:rect l="0" t="0" r="r" b="b"/>
                    <a:pathLst>
                      <a:path w="122" h="52">
                        <a:moveTo>
                          <a:pt x="12" y="0"/>
                        </a:moveTo>
                        <a:lnTo>
                          <a:pt x="18" y="0"/>
                        </a:lnTo>
                        <a:lnTo>
                          <a:pt x="18" y="6"/>
                        </a:lnTo>
                        <a:lnTo>
                          <a:pt x="12" y="6"/>
                        </a:lnTo>
                        <a:lnTo>
                          <a:pt x="12" y="0"/>
                        </a:lnTo>
                        <a:close/>
                        <a:moveTo>
                          <a:pt x="35" y="0"/>
                        </a:moveTo>
                        <a:lnTo>
                          <a:pt x="41" y="0"/>
                        </a:lnTo>
                        <a:lnTo>
                          <a:pt x="41" y="6"/>
                        </a:lnTo>
                        <a:lnTo>
                          <a:pt x="35" y="6"/>
                        </a:lnTo>
                        <a:lnTo>
                          <a:pt x="35" y="0"/>
                        </a:lnTo>
                        <a:close/>
                        <a:moveTo>
                          <a:pt x="58" y="0"/>
                        </a:moveTo>
                        <a:lnTo>
                          <a:pt x="64" y="0"/>
                        </a:lnTo>
                        <a:lnTo>
                          <a:pt x="64" y="6"/>
                        </a:lnTo>
                        <a:lnTo>
                          <a:pt x="58" y="6"/>
                        </a:lnTo>
                        <a:lnTo>
                          <a:pt x="58" y="0"/>
                        </a:lnTo>
                        <a:close/>
                        <a:moveTo>
                          <a:pt x="81" y="0"/>
                        </a:moveTo>
                        <a:lnTo>
                          <a:pt x="87" y="0"/>
                        </a:lnTo>
                        <a:lnTo>
                          <a:pt x="87" y="6"/>
                        </a:lnTo>
                        <a:lnTo>
                          <a:pt x="81" y="6"/>
                        </a:lnTo>
                        <a:lnTo>
                          <a:pt x="81" y="0"/>
                        </a:lnTo>
                        <a:close/>
                        <a:moveTo>
                          <a:pt x="105" y="0"/>
                        </a:moveTo>
                        <a:lnTo>
                          <a:pt x="110" y="0"/>
                        </a:lnTo>
                        <a:lnTo>
                          <a:pt x="110" y="6"/>
                        </a:lnTo>
                        <a:lnTo>
                          <a:pt x="105" y="6"/>
                        </a:lnTo>
                        <a:lnTo>
                          <a:pt x="105" y="0"/>
                        </a:lnTo>
                        <a:close/>
                        <a:moveTo>
                          <a:pt x="0" y="23"/>
                        </a:moveTo>
                        <a:lnTo>
                          <a:pt x="6" y="23"/>
                        </a:lnTo>
                        <a:lnTo>
                          <a:pt x="6" y="29"/>
                        </a:lnTo>
                        <a:lnTo>
                          <a:pt x="0" y="29"/>
                        </a:lnTo>
                        <a:lnTo>
                          <a:pt x="0" y="23"/>
                        </a:lnTo>
                        <a:close/>
                        <a:moveTo>
                          <a:pt x="24" y="23"/>
                        </a:moveTo>
                        <a:lnTo>
                          <a:pt x="29" y="23"/>
                        </a:lnTo>
                        <a:lnTo>
                          <a:pt x="29" y="29"/>
                        </a:lnTo>
                        <a:lnTo>
                          <a:pt x="24" y="29"/>
                        </a:lnTo>
                        <a:lnTo>
                          <a:pt x="24" y="23"/>
                        </a:lnTo>
                        <a:close/>
                        <a:moveTo>
                          <a:pt x="47" y="23"/>
                        </a:moveTo>
                        <a:lnTo>
                          <a:pt x="53" y="23"/>
                        </a:lnTo>
                        <a:lnTo>
                          <a:pt x="53" y="29"/>
                        </a:lnTo>
                        <a:lnTo>
                          <a:pt x="47" y="29"/>
                        </a:lnTo>
                        <a:lnTo>
                          <a:pt x="47" y="23"/>
                        </a:lnTo>
                        <a:close/>
                        <a:moveTo>
                          <a:pt x="70" y="23"/>
                        </a:moveTo>
                        <a:lnTo>
                          <a:pt x="76" y="23"/>
                        </a:lnTo>
                        <a:lnTo>
                          <a:pt x="76" y="29"/>
                        </a:lnTo>
                        <a:lnTo>
                          <a:pt x="70" y="29"/>
                        </a:lnTo>
                        <a:lnTo>
                          <a:pt x="70" y="23"/>
                        </a:lnTo>
                        <a:close/>
                        <a:moveTo>
                          <a:pt x="93" y="23"/>
                        </a:moveTo>
                        <a:lnTo>
                          <a:pt x="99" y="23"/>
                        </a:lnTo>
                        <a:lnTo>
                          <a:pt x="99" y="29"/>
                        </a:lnTo>
                        <a:lnTo>
                          <a:pt x="93" y="29"/>
                        </a:lnTo>
                        <a:lnTo>
                          <a:pt x="93" y="23"/>
                        </a:lnTo>
                        <a:close/>
                        <a:moveTo>
                          <a:pt x="116" y="23"/>
                        </a:moveTo>
                        <a:lnTo>
                          <a:pt x="122" y="23"/>
                        </a:lnTo>
                        <a:lnTo>
                          <a:pt x="122" y="29"/>
                        </a:lnTo>
                        <a:lnTo>
                          <a:pt x="116" y="29"/>
                        </a:lnTo>
                        <a:lnTo>
                          <a:pt x="116" y="23"/>
                        </a:lnTo>
                        <a:close/>
                        <a:moveTo>
                          <a:pt x="12" y="46"/>
                        </a:moveTo>
                        <a:lnTo>
                          <a:pt x="18" y="46"/>
                        </a:lnTo>
                        <a:lnTo>
                          <a:pt x="18" y="52"/>
                        </a:lnTo>
                        <a:lnTo>
                          <a:pt x="12" y="52"/>
                        </a:lnTo>
                        <a:lnTo>
                          <a:pt x="12" y="46"/>
                        </a:lnTo>
                        <a:close/>
                        <a:moveTo>
                          <a:pt x="35" y="46"/>
                        </a:moveTo>
                        <a:lnTo>
                          <a:pt x="41" y="46"/>
                        </a:lnTo>
                        <a:lnTo>
                          <a:pt x="41" y="52"/>
                        </a:lnTo>
                        <a:lnTo>
                          <a:pt x="35" y="52"/>
                        </a:lnTo>
                        <a:lnTo>
                          <a:pt x="35" y="46"/>
                        </a:lnTo>
                        <a:close/>
                        <a:moveTo>
                          <a:pt x="58" y="46"/>
                        </a:moveTo>
                        <a:lnTo>
                          <a:pt x="64" y="46"/>
                        </a:lnTo>
                        <a:lnTo>
                          <a:pt x="64" y="52"/>
                        </a:lnTo>
                        <a:lnTo>
                          <a:pt x="58" y="52"/>
                        </a:lnTo>
                        <a:lnTo>
                          <a:pt x="58" y="46"/>
                        </a:lnTo>
                        <a:close/>
                        <a:moveTo>
                          <a:pt x="81" y="46"/>
                        </a:moveTo>
                        <a:lnTo>
                          <a:pt x="87" y="46"/>
                        </a:lnTo>
                        <a:lnTo>
                          <a:pt x="87" y="52"/>
                        </a:lnTo>
                        <a:lnTo>
                          <a:pt x="81" y="52"/>
                        </a:lnTo>
                        <a:lnTo>
                          <a:pt x="81" y="46"/>
                        </a:lnTo>
                        <a:close/>
                        <a:moveTo>
                          <a:pt x="105" y="46"/>
                        </a:moveTo>
                        <a:lnTo>
                          <a:pt x="110" y="46"/>
                        </a:lnTo>
                        <a:lnTo>
                          <a:pt x="110" y="52"/>
                        </a:lnTo>
                        <a:lnTo>
                          <a:pt x="105" y="52"/>
                        </a:lnTo>
                        <a:lnTo>
                          <a:pt x="105" y="46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83873" tIns="41936" rIns="83873" bIns="41936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GB" sz="1537"/>
                  </a:p>
                </p:txBody>
              </p:sp>
            </p:grpSp>
          </p:grpSp>
          <p:grpSp>
            <p:nvGrpSpPr>
              <p:cNvPr id="40" name="Gruppo 39"/>
              <p:cNvGrpSpPr/>
              <p:nvPr/>
            </p:nvGrpSpPr>
            <p:grpSpPr>
              <a:xfrm>
                <a:off x="4563598" y="662499"/>
                <a:ext cx="1209877" cy="150993"/>
                <a:chOff x="6975980" y="-6070146"/>
                <a:chExt cx="1209877" cy="150993"/>
              </a:xfrm>
            </p:grpSpPr>
            <p:sp>
              <p:nvSpPr>
                <p:cNvPr id="44" name="Rectangle 330">
                  <a:extLst>
                    <a:ext uri="{FF2B5EF4-FFF2-40B4-BE49-F238E27FC236}">
                      <a16:creationId xmlns="" xmlns:a16="http://schemas.microsoft.com/office/drawing/2014/main" id="{5E890020-5560-4C14-BB2F-F696E2FCA5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40387" y="-6070146"/>
                  <a:ext cx="945470" cy="1509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838688"/>
                  <a:r>
                    <a:rPr lang="it-IT" altLang="it-IT" sz="9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LPS </a:t>
                  </a:r>
                  <a:r>
                    <a:rPr lang="it-IT" altLang="it-IT" sz="900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dult</a:t>
                  </a:r>
                  <a:r>
                    <a:rPr lang="it-IT" altLang="it-IT" sz="9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it-IT" altLang="it-IT" sz="900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emale</a:t>
                  </a:r>
                  <a:endParaRPr lang="it-IT" altLang="it-IT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Rectangle 331">
                  <a:extLst>
                    <a:ext uri="{FF2B5EF4-FFF2-40B4-BE49-F238E27FC236}">
                      <a16:creationId xmlns="" xmlns:a16="http://schemas.microsoft.com/office/drawing/2014/main" id="{0A0CD0C7-B079-4152-A74D-FC9C2AF65A8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975980" y="-6048051"/>
                  <a:ext cx="198438" cy="111125"/>
                </a:xfrm>
                <a:prstGeom prst="rect">
                  <a:avLst/>
                </a:prstGeom>
                <a:solidFill>
                  <a:srgbClr val="FF808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83873" tIns="41936" rIns="83873" bIns="41936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900"/>
                </a:p>
              </p:txBody>
            </p:sp>
          </p:grpSp>
          <p:grpSp>
            <p:nvGrpSpPr>
              <p:cNvPr id="41" name="Gruppo 40"/>
              <p:cNvGrpSpPr/>
              <p:nvPr/>
            </p:nvGrpSpPr>
            <p:grpSpPr>
              <a:xfrm>
                <a:off x="2142791" y="666005"/>
                <a:ext cx="1120901" cy="150993"/>
                <a:chOff x="4557117" y="-6313970"/>
                <a:chExt cx="1120901" cy="150993"/>
              </a:xfrm>
            </p:grpSpPr>
            <p:sp>
              <p:nvSpPr>
                <p:cNvPr id="42" name="Rectangle 329">
                  <a:extLst>
                    <a:ext uri="{FF2B5EF4-FFF2-40B4-BE49-F238E27FC236}">
                      <a16:creationId xmlns="" xmlns:a16="http://schemas.microsoft.com/office/drawing/2014/main" id="{C7349124-D39B-4FFD-BA6A-7D98DBF485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30416" y="-6313970"/>
                  <a:ext cx="847602" cy="15099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838688"/>
                  <a:r>
                    <a:rPr lang="it-IT" altLang="it-IT" sz="9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LPS </a:t>
                  </a:r>
                  <a:r>
                    <a:rPr lang="it-IT" altLang="it-IT" sz="900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dult</a:t>
                  </a:r>
                  <a:r>
                    <a:rPr lang="it-IT" altLang="it-IT" sz="9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ale</a:t>
                  </a:r>
                  <a:endParaRPr lang="it-IT" altLang="it-IT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Rectangle 332">
                  <a:extLst>
                    <a:ext uri="{FF2B5EF4-FFF2-40B4-BE49-F238E27FC236}">
                      <a16:creationId xmlns="" xmlns:a16="http://schemas.microsoft.com/office/drawing/2014/main" id="{BA339ADC-6AAC-455A-B300-43AB64D294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57117" y="-6288320"/>
                  <a:ext cx="196850" cy="107950"/>
                </a:xfrm>
                <a:prstGeom prst="rect">
                  <a:avLst/>
                </a:prstGeom>
                <a:solidFill>
                  <a:srgbClr val="0F99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83873" tIns="41936" rIns="83873" bIns="41936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sz="1400"/>
                </a:p>
              </p:txBody>
            </p:sp>
          </p:grpSp>
        </p:grpSp>
        <p:grpSp>
          <p:nvGrpSpPr>
            <p:cNvPr id="185" name="Gruppo 184"/>
            <p:cNvGrpSpPr/>
            <p:nvPr/>
          </p:nvGrpSpPr>
          <p:grpSpPr>
            <a:xfrm>
              <a:off x="1671832" y="728655"/>
              <a:ext cx="4880268" cy="7133884"/>
              <a:chOff x="1611757" y="854557"/>
              <a:chExt cx="5320587" cy="7777534"/>
            </a:xfrm>
          </p:grpSpPr>
          <p:sp>
            <p:nvSpPr>
              <p:cNvPr id="8" name="CasellaDiTesto 7">
                <a:extLst>
                  <a:ext uri="{FF2B5EF4-FFF2-40B4-BE49-F238E27FC236}">
                    <a16:creationId xmlns="" xmlns:a16="http://schemas.microsoft.com/office/drawing/2014/main" id="{54204443-91C1-4247-8623-E6F868795816}"/>
                  </a:ext>
                </a:extLst>
              </p:cNvPr>
              <p:cNvSpPr txBox="1"/>
              <p:nvPr/>
            </p:nvSpPr>
            <p:spPr>
              <a:xfrm>
                <a:off x="2000461" y="933297"/>
                <a:ext cx="1098582" cy="3469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68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tex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="" xmlns:a16="http://schemas.microsoft.com/office/drawing/2014/main" id="{DFF38024-9396-46A2-A40A-5AA93CAF31C1}"/>
                  </a:ext>
                </a:extLst>
              </p:cNvPr>
              <p:cNvSpPr txBox="1"/>
              <p:nvPr/>
            </p:nvSpPr>
            <p:spPr>
              <a:xfrm>
                <a:off x="2000461" y="3627383"/>
                <a:ext cx="2002497" cy="3469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68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ppocampus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="" xmlns:a16="http://schemas.microsoft.com/office/drawing/2014/main" id="{26661744-11CA-4104-BC26-62A735A09363}"/>
                  </a:ext>
                </a:extLst>
              </p:cNvPr>
              <p:cNvSpPr txBox="1"/>
              <p:nvPr/>
            </p:nvSpPr>
            <p:spPr>
              <a:xfrm>
                <a:off x="1992353" y="6228695"/>
                <a:ext cx="1678589" cy="3469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68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rebellum</a:t>
                </a:r>
              </a:p>
            </p:txBody>
          </p:sp>
          <p:sp>
            <p:nvSpPr>
              <p:cNvPr id="33" name="CasellaDiTesto 32"/>
              <p:cNvSpPr txBox="1"/>
              <p:nvPr/>
            </p:nvSpPr>
            <p:spPr>
              <a:xfrm>
                <a:off x="1640994" y="921851"/>
                <a:ext cx="158105" cy="3691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4" name="CasellaDiTesto 33"/>
              <p:cNvSpPr txBox="1"/>
              <p:nvPr/>
            </p:nvSpPr>
            <p:spPr>
              <a:xfrm>
                <a:off x="4356389" y="854557"/>
                <a:ext cx="235266" cy="3691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grpSp>
            <p:nvGrpSpPr>
              <p:cNvPr id="180" name="Gruppo 179"/>
              <p:cNvGrpSpPr/>
              <p:nvPr/>
            </p:nvGrpSpPr>
            <p:grpSpPr>
              <a:xfrm>
                <a:off x="1611757" y="6329549"/>
                <a:ext cx="5319260" cy="2302542"/>
                <a:chOff x="1611757" y="6185169"/>
                <a:chExt cx="5319260" cy="2302542"/>
              </a:xfrm>
            </p:grpSpPr>
            <p:sp>
              <p:nvSpPr>
                <p:cNvPr id="22" name="CasellaDiTesto 6">
                  <a:extLst>
                    <a:ext uri="{FF2B5EF4-FFF2-40B4-BE49-F238E27FC236}">
                      <a16:creationId xmlns="" xmlns:a16="http://schemas.microsoft.com/office/drawing/2014/main" id="{8683E54E-62C7-4C3D-93CF-F59796759D92}"/>
                    </a:ext>
                  </a:extLst>
                </p:cNvPr>
                <p:cNvSpPr txBox="1"/>
                <p:nvPr/>
              </p:nvSpPr>
              <p:spPr>
                <a:xfrm rot="16200000">
                  <a:off x="3462038" y="6841735"/>
                  <a:ext cx="1598485" cy="2853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issue/blood ratio</a:t>
                  </a:r>
                </a:p>
              </p:txBody>
            </p:sp>
            <p:graphicFrame>
              <p:nvGraphicFramePr>
                <p:cNvPr id="4" name="Oggetto 3"/>
                <p:cNvGraphicFramePr>
                  <a:graphicFrameLocks/>
                </p:cNvGraphicFramePr>
                <p:nvPr/>
              </p:nvGraphicFramePr>
              <p:xfrm>
                <a:off x="1799305" y="6330025"/>
                <a:ext cx="2250000" cy="17100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5206" name="Prism 6" r:id="rId4" imgW="3091765" imgH="2206304" progId="Prism6.Document">
                        <p:embed/>
                      </p:oleObj>
                    </mc:Choice>
                    <mc:Fallback>
                      <p:oleObj name="Prism 6" r:id="rId4" imgW="3091765" imgH="2206304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799305" y="6330025"/>
                              <a:ext cx="2250000" cy="17100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7" name="Oggetto 6"/>
                <p:cNvGraphicFramePr>
                  <a:graphicFrameLocks/>
                </p:cNvGraphicFramePr>
                <p:nvPr/>
              </p:nvGraphicFramePr>
              <p:xfrm>
                <a:off x="4314066" y="6325244"/>
                <a:ext cx="2250000" cy="17100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5207" name="Prism 6" r:id="rId6" imgW="3091765" imgH="2206304" progId="Prism6.Document">
                        <p:embed/>
                      </p:oleObj>
                    </mc:Choice>
                    <mc:Fallback>
                      <p:oleObj name="Prism 6" r:id="rId6" imgW="3091765" imgH="2206304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314066" y="6325244"/>
                              <a:ext cx="2250000" cy="17100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6" name="CasellaDiTesto 6">
                  <a:extLst>
                    <a:ext uri="{FF2B5EF4-FFF2-40B4-BE49-F238E27FC236}">
                      <a16:creationId xmlns="" xmlns:a16="http://schemas.microsoft.com/office/drawing/2014/main" id="{8683E54E-62C7-4C3D-93CF-F59796759D92}"/>
                    </a:ext>
                  </a:extLst>
                </p:cNvPr>
                <p:cNvSpPr txBox="1"/>
                <p:nvPr/>
              </p:nvSpPr>
              <p:spPr>
                <a:xfrm rot="16200000">
                  <a:off x="955191" y="6845519"/>
                  <a:ext cx="1598485" cy="2853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issue/blood ratio</a:t>
                  </a:r>
                </a:p>
              </p:txBody>
            </p:sp>
            <p:grpSp>
              <p:nvGrpSpPr>
                <p:cNvPr id="114" name="Gruppo 113"/>
                <p:cNvGrpSpPr/>
                <p:nvPr/>
              </p:nvGrpSpPr>
              <p:grpSpPr>
                <a:xfrm>
                  <a:off x="1657752" y="7849043"/>
                  <a:ext cx="2749979" cy="638668"/>
                  <a:chOff x="1619763" y="2770297"/>
                  <a:chExt cx="2749979" cy="638668"/>
                </a:xfrm>
              </p:grpSpPr>
              <p:sp>
                <p:nvSpPr>
                  <p:cNvPr id="115" name="CasellaDiTesto 6">
                    <a:extLst>
                      <a:ext uri="{FF2B5EF4-FFF2-40B4-BE49-F238E27FC236}">
                        <a16:creationId xmlns="" xmlns:a16="http://schemas.microsoft.com/office/drawing/2014/main" id="{81EDA090-2EC6-4370-BCB0-C13F48BE519C}"/>
                      </a:ext>
                    </a:extLst>
                  </p:cNvPr>
                  <p:cNvSpPr txBox="1"/>
                  <p:nvPr/>
                </p:nvSpPr>
                <p:spPr>
                  <a:xfrm>
                    <a:off x="2095404" y="3092618"/>
                    <a:ext cx="1326854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dult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6" name="CasellaDiTesto 6">
                    <a:extLst>
                      <a:ext uri="{FF2B5EF4-FFF2-40B4-BE49-F238E27FC236}">
                        <a16:creationId xmlns="" xmlns:a16="http://schemas.microsoft.com/office/drawing/2014/main" id="{D38299FE-80FE-40EF-B4C1-1EA1D0FF2218}"/>
                      </a:ext>
                    </a:extLst>
                  </p:cNvPr>
                  <p:cNvSpPr txBox="1"/>
                  <p:nvPr/>
                </p:nvSpPr>
                <p:spPr>
                  <a:xfrm>
                    <a:off x="3176469" y="3092853"/>
                    <a:ext cx="1193273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ed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17" name="Gruppo 116"/>
                  <p:cNvGrpSpPr/>
                  <p:nvPr/>
                </p:nvGrpSpPr>
                <p:grpSpPr>
                  <a:xfrm>
                    <a:off x="1619763" y="2770297"/>
                    <a:ext cx="2229516" cy="365643"/>
                    <a:chOff x="1619763" y="2770297"/>
                    <a:chExt cx="2229516" cy="365643"/>
                  </a:xfrm>
                </p:grpSpPr>
                <p:sp>
                  <p:nvSpPr>
                    <p:cNvPr id="118" name="CasellaDiTesto 117">
                      <a:extLst>
                        <a:ext uri="{FF2B5EF4-FFF2-40B4-BE49-F238E27FC236}">
                          <a16:creationId xmlns="" xmlns:a16="http://schemas.microsoft.com/office/drawing/2014/main" id="{A2341639-2B4B-4060-8627-F26FBC595A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79065" y="279971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19" name="CasellaDiTesto 118">
                      <a:extLst>
                        <a:ext uri="{FF2B5EF4-FFF2-40B4-BE49-F238E27FC236}">
                          <a16:creationId xmlns="" xmlns:a16="http://schemas.microsoft.com/office/drawing/2014/main" id="{2A2D4FBB-4A88-4AC6-ACBF-26DC2912B89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4880" y="277029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20" name="CasellaDiTesto 119">
                      <a:extLst>
                        <a:ext uri="{FF2B5EF4-FFF2-40B4-BE49-F238E27FC236}">
                          <a16:creationId xmlns="" xmlns:a16="http://schemas.microsoft.com/office/drawing/2014/main" id="{6EBCE0AC-4552-4F22-B8EC-819F01E48F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44932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21" name="CasellaDiTesto 120">
                      <a:extLst>
                        <a:ext uri="{FF2B5EF4-FFF2-40B4-BE49-F238E27FC236}">
                          <a16:creationId xmlns="" xmlns:a16="http://schemas.microsoft.com/office/drawing/2014/main" id="{64D2AA2D-5900-4D20-BF54-5C69178200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99539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22" name="CasellaDiTesto 121">
                      <a:extLst>
                        <a:ext uri="{FF2B5EF4-FFF2-40B4-BE49-F238E27FC236}">
                          <a16:creationId xmlns="" xmlns:a16="http://schemas.microsoft.com/office/drawing/2014/main" id="{E8EC2B3C-50F8-459B-9A9C-1478F4BB14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9763" y="2881414"/>
                      <a:ext cx="585969" cy="2545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17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S</a:t>
                      </a:r>
                    </a:p>
                  </p:txBody>
                </p:sp>
                <p:cxnSp>
                  <p:nvCxnSpPr>
                    <p:cNvPr id="123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28675" y="3051346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061023" y="3060000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25" name="Gruppo 124"/>
                <p:cNvGrpSpPr/>
                <p:nvPr/>
              </p:nvGrpSpPr>
              <p:grpSpPr>
                <a:xfrm>
                  <a:off x="4181038" y="7842543"/>
                  <a:ext cx="2749979" cy="638668"/>
                  <a:chOff x="1619763" y="2770297"/>
                  <a:chExt cx="2749979" cy="638668"/>
                </a:xfrm>
              </p:grpSpPr>
              <p:sp>
                <p:nvSpPr>
                  <p:cNvPr id="126" name="CasellaDiTesto 6">
                    <a:extLst>
                      <a:ext uri="{FF2B5EF4-FFF2-40B4-BE49-F238E27FC236}">
                        <a16:creationId xmlns="" xmlns:a16="http://schemas.microsoft.com/office/drawing/2014/main" id="{81EDA090-2EC6-4370-BCB0-C13F48BE519C}"/>
                      </a:ext>
                    </a:extLst>
                  </p:cNvPr>
                  <p:cNvSpPr txBox="1"/>
                  <p:nvPr/>
                </p:nvSpPr>
                <p:spPr>
                  <a:xfrm>
                    <a:off x="2095404" y="3092618"/>
                    <a:ext cx="1326854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dult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7" name="CasellaDiTesto 6">
                    <a:extLst>
                      <a:ext uri="{FF2B5EF4-FFF2-40B4-BE49-F238E27FC236}">
                        <a16:creationId xmlns="" xmlns:a16="http://schemas.microsoft.com/office/drawing/2014/main" id="{D38299FE-80FE-40EF-B4C1-1EA1D0FF2218}"/>
                      </a:ext>
                    </a:extLst>
                  </p:cNvPr>
                  <p:cNvSpPr txBox="1"/>
                  <p:nvPr/>
                </p:nvSpPr>
                <p:spPr>
                  <a:xfrm>
                    <a:off x="3176469" y="3092853"/>
                    <a:ext cx="1193273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ed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28" name="Gruppo 127"/>
                  <p:cNvGrpSpPr/>
                  <p:nvPr/>
                </p:nvGrpSpPr>
                <p:grpSpPr>
                  <a:xfrm>
                    <a:off x="1619763" y="2770297"/>
                    <a:ext cx="2229516" cy="365643"/>
                    <a:chOff x="1619763" y="2770297"/>
                    <a:chExt cx="2229516" cy="365643"/>
                  </a:xfrm>
                </p:grpSpPr>
                <p:sp>
                  <p:nvSpPr>
                    <p:cNvPr id="129" name="CasellaDiTesto 128">
                      <a:extLst>
                        <a:ext uri="{FF2B5EF4-FFF2-40B4-BE49-F238E27FC236}">
                          <a16:creationId xmlns="" xmlns:a16="http://schemas.microsoft.com/office/drawing/2014/main" id="{A2341639-2B4B-4060-8627-F26FBC595A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79065" y="279971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30" name="CasellaDiTesto 129">
                      <a:extLst>
                        <a:ext uri="{FF2B5EF4-FFF2-40B4-BE49-F238E27FC236}">
                          <a16:creationId xmlns="" xmlns:a16="http://schemas.microsoft.com/office/drawing/2014/main" id="{2A2D4FBB-4A88-4AC6-ACBF-26DC2912B89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4880" y="277029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31" name="CasellaDiTesto 130">
                      <a:extLst>
                        <a:ext uri="{FF2B5EF4-FFF2-40B4-BE49-F238E27FC236}">
                          <a16:creationId xmlns="" xmlns:a16="http://schemas.microsoft.com/office/drawing/2014/main" id="{6EBCE0AC-4552-4F22-B8EC-819F01E48F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44932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32" name="CasellaDiTesto 131">
                      <a:extLst>
                        <a:ext uri="{FF2B5EF4-FFF2-40B4-BE49-F238E27FC236}">
                          <a16:creationId xmlns="" xmlns:a16="http://schemas.microsoft.com/office/drawing/2014/main" id="{64D2AA2D-5900-4D20-BF54-5C69178200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99539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33" name="CasellaDiTesto 132">
                      <a:extLst>
                        <a:ext uri="{FF2B5EF4-FFF2-40B4-BE49-F238E27FC236}">
                          <a16:creationId xmlns="" xmlns:a16="http://schemas.microsoft.com/office/drawing/2014/main" id="{E8EC2B3C-50F8-459B-9A9C-1478F4BB14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9763" y="2881414"/>
                      <a:ext cx="585969" cy="2545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17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S</a:t>
                      </a:r>
                    </a:p>
                  </p:txBody>
                </p:sp>
                <p:cxnSp>
                  <p:nvCxnSpPr>
                    <p:cNvPr id="134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28675" y="3051346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5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061023" y="3060000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26" name="Gruppo 25"/>
              <p:cNvGrpSpPr/>
              <p:nvPr/>
            </p:nvGrpSpPr>
            <p:grpSpPr>
              <a:xfrm>
                <a:off x="1612712" y="3806880"/>
                <a:ext cx="5319630" cy="2217249"/>
                <a:chOff x="1612712" y="3806880"/>
                <a:chExt cx="5319630" cy="2217249"/>
              </a:xfrm>
            </p:grpSpPr>
            <p:graphicFrame>
              <p:nvGraphicFramePr>
                <p:cNvPr id="3" name="Oggetto 2"/>
                <p:cNvGraphicFramePr>
                  <a:graphicFrameLocks/>
                </p:cNvGraphicFramePr>
                <p:nvPr/>
              </p:nvGraphicFramePr>
              <p:xfrm>
                <a:off x="1794930" y="3868742"/>
                <a:ext cx="2250000" cy="17100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5208" name="Prism 6" r:id="rId8" imgW="3091765" imgH="2206304" progId="Prism6.Document">
                        <p:embed/>
                      </p:oleObj>
                    </mc:Choice>
                    <mc:Fallback>
                      <p:oleObj name="Prism 6" r:id="rId8" imgW="3091765" imgH="2206304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794930" y="3868742"/>
                              <a:ext cx="2250000" cy="17100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3" name="CasellaDiTesto 6">
                  <a:extLst>
                    <a:ext uri="{FF2B5EF4-FFF2-40B4-BE49-F238E27FC236}">
                      <a16:creationId xmlns="" xmlns:a16="http://schemas.microsoft.com/office/drawing/2014/main" id="{8683E54E-62C7-4C3D-93CF-F59796759D92}"/>
                    </a:ext>
                  </a:extLst>
                </p:cNvPr>
                <p:cNvSpPr txBox="1"/>
                <p:nvPr/>
              </p:nvSpPr>
              <p:spPr>
                <a:xfrm rot="16200000">
                  <a:off x="956147" y="4463445"/>
                  <a:ext cx="1598484" cy="2853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issue/blood ratio</a:t>
                  </a:r>
                </a:p>
              </p:txBody>
            </p:sp>
            <p:sp>
              <p:nvSpPr>
                <p:cNvPr id="19" name="CasellaDiTesto 6">
                  <a:extLst>
                    <a:ext uri="{FF2B5EF4-FFF2-40B4-BE49-F238E27FC236}">
                      <a16:creationId xmlns="" xmlns:a16="http://schemas.microsoft.com/office/drawing/2014/main" id="{8683E54E-62C7-4C3D-93CF-F59796759D92}"/>
                    </a:ext>
                  </a:extLst>
                </p:cNvPr>
                <p:cNvSpPr txBox="1"/>
                <p:nvPr/>
              </p:nvSpPr>
              <p:spPr>
                <a:xfrm rot="16200000">
                  <a:off x="3490759" y="4525308"/>
                  <a:ext cx="1598485" cy="2853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issue/blood ratio</a:t>
                  </a:r>
                </a:p>
              </p:txBody>
            </p:sp>
            <p:graphicFrame>
              <p:nvGraphicFramePr>
                <p:cNvPr id="72" name="Oggetto 71"/>
                <p:cNvGraphicFramePr>
                  <a:graphicFrameLocks/>
                </p:cNvGraphicFramePr>
                <p:nvPr/>
              </p:nvGraphicFramePr>
              <p:xfrm>
                <a:off x="4314066" y="3868743"/>
                <a:ext cx="2250000" cy="17100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5209" name="Prism 6" r:id="rId10" imgW="3091765" imgH="2206304" progId="Prism6.Document">
                        <p:embed/>
                      </p:oleObj>
                    </mc:Choice>
                    <mc:Fallback>
                      <p:oleObj name="Prism 6" r:id="rId10" imgW="3091765" imgH="2206304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314066" y="3868743"/>
                              <a:ext cx="2250000" cy="17100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36" name="Gruppo 135"/>
                <p:cNvGrpSpPr/>
                <p:nvPr/>
              </p:nvGrpSpPr>
              <p:grpSpPr>
                <a:xfrm>
                  <a:off x="1659077" y="5385461"/>
                  <a:ext cx="2749979" cy="638668"/>
                  <a:chOff x="1619763" y="2770297"/>
                  <a:chExt cx="2749979" cy="638668"/>
                </a:xfrm>
              </p:grpSpPr>
              <p:sp>
                <p:nvSpPr>
                  <p:cNvPr id="137" name="CasellaDiTesto 6">
                    <a:extLst>
                      <a:ext uri="{FF2B5EF4-FFF2-40B4-BE49-F238E27FC236}">
                        <a16:creationId xmlns="" xmlns:a16="http://schemas.microsoft.com/office/drawing/2014/main" id="{81EDA090-2EC6-4370-BCB0-C13F48BE519C}"/>
                      </a:ext>
                    </a:extLst>
                  </p:cNvPr>
                  <p:cNvSpPr txBox="1"/>
                  <p:nvPr/>
                </p:nvSpPr>
                <p:spPr>
                  <a:xfrm>
                    <a:off x="2095404" y="3092618"/>
                    <a:ext cx="1326854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dult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8" name="CasellaDiTesto 6">
                    <a:extLst>
                      <a:ext uri="{FF2B5EF4-FFF2-40B4-BE49-F238E27FC236}">
                        <a16:creationId xmlns="" xmlns:a16="http://schemas.microsoft.com/office/drawing/2014/main" id="{D38299FE-80FE-40EF-B4C1-1EA1D0FF2218}"/>
                      </a:ext>
                    </a:extLst>
                  </p:cNvPr>
                  <p:cNvSpPr txBox="1"/>
                  <p:nvPr/>
                </p:nvSpPr>
                <p:spPr>
                  <a:xfrm>
                    <a:off x="3176469" y="3092853"/>
                    <a:ext cx="1193273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ed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39" name="Gruppo 138"/>
                  <p:cNvGrpSpPr/>
                  <p:nvPr/>
                </p:nvGrpSpPr>
                <p:grpSpPr>
                  <a:xfrm>
                    <a:off x="1619763" y="2770297"/>
                    <a:ext cx="2229516" cy="365643"/>
                    <a:chOff x="1619763" y="2770297"/>
                    <a:chExt cx="2229516" cy="365643"/>
                  </a:xfrm>
                </p:grpSpPr>
                <p:sp>
                  <p:nvSpPr>
                    <p:cNvPr id="140" name="CasellaDiTesto 139">
                      <a:extLst>
                        <a:ext uri="{FF2B5EF4-FFF2-40B4-BE49-F238E27FC236}">
                          <a16:creationId xmlns="" xmlns:a16="http://schemas.microsoft.com/office/drawing/2014/main" id="{A2341639-2B4B-4060-8627-F26FBC595A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79065" y="279971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41" name="CasellaDiTesto 140">
                      <a:extLst>
                        <a:ext uri="{FF2B5EF4-FFF2-40B4-BE49-F238E27FC236}">
                          <a16:creationId xmlns="" xmlns:a16="http://schemas.microsoft.com/office/drawing/2014/main" id="{2A2D4FBB-4A88-4AC6-ACBF-26DC2912B89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4880" y="277029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42" name="CasellaDiTesto 141">
                      <a:extLst>
                        <a:ext uri="{FF2B5EF4-FFF2-40B4-BE49-F238E27FC236}">
                          <a16:creationId xmlns="" xmlns:a16="http://schemas.microsoft.com/office/drawing/2014/main" id="{6EBCE0AC-4552-4F22-B8EC-819F01E48F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44932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43" name="CasellaDiTesto 142">
                      <a:extLst>
                        <a:ext uri="{FF2B5EF4-FFF2-40B4-BE49-F238E27FC236}">
                          <a16:creationId xmlns="" xmlns:a16="http://schemas.microsoft.com/office/drawing/2014/main" id="{64D2AA2D-5900-4D20-BF54-5C69178200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99539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44" name="CasellaDiTesto 143">
                      <a:extLst>
                        <a:ext uri="{FF2B5EF4-FFF2-40B4-BE49-F238E27FC236}">
                          <a16:creationId xmlns="" xmlns:a16="http://schemas.microsoft.com/office/drawing/2014/main" id="{E8EC2B3C-50F8-459B-9A9C-1478F4BB14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9763" y="2881414"/>
                      <a:ext cx="585969" cy="2545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17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S</a:t>
                      </a:r>
                    </a:p>
                  </p:txBody>
                </p:sp>
                <p:cxnSp>
                  <p:nvCxnSpPr>
                    <p:cNvPr id="145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28675" y="3051346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6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061023" y="3060000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47" name="Gruppo 146"/>
                <p:cNvGrpSpPr/>
                <p:nvPr/>
              </p:nvGrpSpPr>
              <p:grpSpPr>
                <a:xfrm>
                  <a:off x="4182363" y="5378961"/>
                  <a:ext cx="2749979" cy="638668"/>
                  <a:chOff x="1619763" y="2770297"/>
                  <a:chExt cx="2749979" cy="638668"/>
                </a:xfrm>
              </p:grpSpPr>
              <p:sp>
                <p:nvSpPr>
                  <p:cNvPr id="148" name="CasellaDiTesto 6">
                    <a:extLst>
                      <a:ext uri="{FF2B5EF4-FFF2-40B4-BE49-F238E27FC236}">
                        <a16:creationId xmlns="" xmlns:a16="http://schemas.microsoft.com/office/drawing/2014/main" id="{81EDA090-2EC6-4370-BCB0-C13F48BE519C}"/>
                      </a:ext>
                    </a:extLst>
                  </p:cNvPr>
                  <p:cNvSpPr txBox="1"/>
                  <p:nvPr/>
                </p:nvSpPr>
                <p:spPr>
                  <a:xfrm>
                    <a:off x="2095404" y="3092618"/>
                    <a:ext cx="1326854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dult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9" name="CasellaDiTesto 6">
                    <a:extLst>
                      <a:ext uri="{FF2B5EF4-FFF2-40B4-BE49-F238E27FC236}">
                        <a16:creationId xmlns="" xmlns:a16="http://schemas.microsoft.com/office/drawing/2014/main" id="{D38299FE-80FE-40EF-B4C1-1EA1D0FF2218}"/>
                      </a:ext>
                    </a:extLst>
                  </p:cNvPr>
                  <p:cNvSpPr txBox="1"/>
                  <p:nvPr/>
                </p:nvSpPr>
                <p:spPr>
                  <a:xfrm>
                    <a:off x="3176469" y="3092853"/>
                    <a:ext cx="1193273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ed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50" name="Gruppo 149"/>
                  <p:cNvGrpSpPr/>
                  <p:nvPr/>
                </p:nvGrpSpPr>
                <p:grpSpPr>
                  <a:xfrm>
                    <a:off x="1619763" y="2770297"/>
                    <a:ext cx="2229516" cy="365643"/>
                    <a:chOff x="1619763" y="2770297"/>
                    <a:chExt cx="2229516" cy="365643"/>
                  </a:xfrm>
                </p:grpSpPr>
                <p:sp>
                  <p:nvSpPr>
                    <p:cNvPr id="151" name="CasellaDiTesto 150">
                      <a:extLst>
                        <a:ext uri="{FF2B5EF4-FFF2-40B4-BE49-F238E27FC236}">
                          <a16:creationId xmlns="" xmlns:a16="http://schemas.microsoft.com/office/drawing/2014/main" id="{A2341639-2B4B-4060-8627-F26FBC595A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79065" y="279971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52" name="CasellaDiTesto 151">
                      <a:extLst>
                        <a:ext uri="{FF2B5EF4-FFF2-40B4-BE49-F238E27FC236}">
                          <a16:creationId xmlns="" xmlns:a16="http://schemas.microsoft.com/office/drawing/2014/main" id="{2A2D4FBB-4A88-4AC6-ACBF-26DC2912B89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4880" y="277029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53" name="CasellaDiTesto 152">
                      <a:extLst>
                        <a:ext uri="{FF2B5EF4-FFF2-40B4-BE49-F238E27FC236}">
                          <a16:creationId xmlns="" xmlns:a16="http://schemas.microsoft.com/office/drawing/2014/main" id="{6EBCE0AC-4552-4F22-B8EC-819F01E48F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44932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54" name="CasellaDiTesto 153">
                      <a:extLst>
                        <a:ext uri="{FF2B5EF4-FFF2-40B4-BE49-F238E27FC236}">
                          <a16:creationId xmlns="" xmlns:a16="http://schemas.microsoft.com/office/drawing/2014/main" id="{64D2AA2D-5900-4D20-BF54-5C69178200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99539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55" name="CasellaDiTesto 154">
                      <a:extLst>
                        <a:ext uri="{FF2B5EF4-FFF2-40B4-BE49-F238E27FC236}">
                          <a16:creationId xmlns="" xmlns:a16="http://schemas.microsoft.com/office/drawing/2014/main" id="{E8EC2B3C-50F8-459B-9A9C-1478F4BB14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9763" y="2881414"/>
                      <a:ext cx="585969" cy="2545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17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S</a:t>
                      </a:r>
                    </a:p>
                  </p:txBody>
                </p:sp>
                <p:cxnSp>
                  <p:nvCxnSpPr>
                    <p:cNvPr id="156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28675" y="3051346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7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061023" y="3060000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25" name="Gruppo 24"/>
              <p:cNvGrpSpPr/>
              <p:nvPr/>
            </p:nvGrpSpPr>
            <p:grpSpPr>
              <a:xfrm>
                <a:off x="1615796" y="1117543"/>
                <a:ext cx="5316548" cy="2290619"/>
                <a:chOff x="1615796" y="1117543"/>
                <a:chExt cx="5316548" cy="2290619"/>
              </a:xfrm>
            </p:grpSpPr>
            <p:graphicFrame>
              <p:nvGraphicFramePr>
                <p:cNvPr id="2" name="Oggetto 1"/>
                <p:cNvGraphicFramePr>
                  <a:graphicFrameLocks/>
                </p:cNvGraphicFramePr>
                <p:nvPr/>
              </p:nvGraphicFramePr>
              <p:xfrm>
                <a:off x="1797637" y="1231458"/>
                <a:ext cx="2250000" cy="17100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5210" name="Prism 6" r:id="rId12" imgW="3091765" imgH="2206304" progId="Prism6.Document">
                        <p:embed/>
                      </p:oleObj>
                    </mc:Choice>
                    <mc:Fallback>
                      <p:oleObj name="Prism 6" r:id="rId12" imgW="3091765" imgH="2206304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797637" y="1231458"/>
                              <a:ext cx="2250000" cy="17100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9" name="CasellaDiTesto 6">
                  <a:extLst>
                    <a:ext uri="{FF2B5EF4-FFF2-40B4-BE49-F238E27FC236}">
                      <a16:creationId xmlns="" xmlns:a16="http://schemas.microsoft.com/office/drawing/2014/main" id="{8683E54E-62C7-4C3D-93CF-F59796759D92}"/>
                    </a:ext>
                  </a:extLst>
                </p:cNvPr>
                <p:cNvSpPr txBox="1"/>
                <p:nvPr/>
              </p:nvSpPr>
              <p:spPr>
                <a:xfrm rot="16200000">
                  <a:off x="959230" y="1774109"/>
                  <a:ext cx="1598485" cy="2853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issue/blood ratio</a:t>
                  </a:r>
                </a:p>
              </p:txBody>
            </p:sp>
            <p:sp>
              <p:nvSpPr>
                <p:cNvPr id="12" name="CasellaDiTesto 6">
                  <a:extLst>
                    <a:ext uri="{FF2B5EF4-FFF2-40B4-BE49-F238E27FC236}">
                      <a16:creationId xmlns="" xmlns:a16="http://schemas.microsoft.com/office/drawing/2014/main" id="{8683E54E-62C7-4C3D-93CF-F59796759D92}"/>
                    </a:ext>
                  </a:extLst>
                </p:cNvPr>
                <p:cNvSpPr txBox="1"/>
                <p:nvPr/>
              </p:nvSpPr>
              <p:spPr>
                <a:xfrm rot="16200000">
                  <a:off x="3470344" y="1885537"/>
                  <a:ext cx="1598485" cy="2853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issue/blood ratio</a:t>
                  </a:r>
                </a:p>
              </p:txBody>
            </p:sp>
            <p:graphicFrame>
              <p:nvGraphicFramePr>
                <p:cNvPr id="71" name="Oggetto 7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359717933"/>
                    </p:ext>
                  </p:extLst>
                </p:nvPr>
              </p:nvGraphicFramePr>
              <p:xfrm>
                <a:off x="4327418" y="1231256"/>
                <a:ext cx="2250000" cy="17100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5211" name="Prism 6" r:id="rId14" imgW="3091765" imgH="2206304" progId="Prism6.Document">
                        <p:embed/>
                      </p:oleObj>
                    </mc:Choice>
                    <mc:Fallback>
                      <p:oleObj name="Prism 6" r:id="rId14" imgW="3091765" imgH="2206304" progId="Prism6.Document">
                        <p:embed/>
                        <p:pic>
                          <p:nvPicPr>
                            <p:cNvPr id="0" name=""/>
                            <p:cNvPicPr preferRelativeResize="0"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327418" y="1231256"/>
                              <a:ext cx="2250000" cy="17100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158" name="Gruppo 157"/>
                <p:cNvGrpSpPr/>
                <p:nvPr/>
              </p:nvGrpSpPr>
              <p:grpSpPr>
                <a:xfrm>
                  <a:off x="1659079" y="2769494"/>
                  <a:ext cx="2749979" cy="638668"/>
                  <a:chOff x="1619763" y="2770297"/>
                  <a:chExt cx="2749979" cy="638668"/>
                </a:xfrm>
              </p:grpSpPr>
              <p:sp>
                <p:nvSpPr>
                  <p:cNvPr id="159" name="CasellaDiTesto 6">
                    <a:extLst>
                      <a:ext uri="{FF2B5EF4-FFF2-40B4-BE49-F238E27FC236}">
                        <a16:creationId xmlns="" xmlns:a16="http://schemas.microsoft.com/office/drawing/2014/main" id="{81EDA090-2EC6-4370-BCB0-C13F48BE519C}"/>
                      </a:ext>
                    </a:extLst>
                  </p:cNvPr>
                  <p:cNvSpPr txBox="1"/>
                  <p:nvPr/>
                </p:nvSpPr>
                <p:spPr>
                  <a:xfrm>
                    <a:off x="2095404" y="3092618"/>
                    <a:ext cx="1326854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dult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0" name="CasellaDiTesto 6">
                    <a:extLst>
                      <a:ext uri="{FF2B5EF4-FFF2-40B4-BE49-F238E27FC236}">
                        <a16:creationId xmlns="" xmlns:a16="http://schemas.microsoft.com/office/drawing/2014/main" id="{D38299FE-80FE-40EF-B4C1-1EA1D0FF2218}"/>
                      </a:ext>
                    </a:extLst>
                  </p:cNvPr>
                  <p:cNvSpPr txBox="1"/>
                  <p:nvPr/>
                </p:nvSpPr>
                <p:spPr>
                  <a:xfrm>
                    <a:off x="3176469" y="3092853"/>
                    <a:ext cx="1193273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ed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61" name="Gruppo 160"/>
                  <p:cNvGrpSpPr/>
                  <p:nvPr/>
                </p:nvGrpSpPr>
                <p:grpSpPr>
                  <a:xfrm>
                    <a:off x="1619763" y="2770297"/>
                    <a:ext cx="2229516" cy="365643"/>
                    <a:chOff x="1619763" y="2770297"/>
                    <a:chExt cx="2229516" cy="365643"/>
                  </a:xfrm>
                </p:grpSpPr>
                <p:sp>
                  <p:nvSpPr>
                    <p:cNvPr id="162" name="CasellaDiTesto 161">
                      <a:extLst>
                        <a:ext uri="{FF2B5EF4-FFF2-40B4-BE49-F238E27FC236}">
                          <a16:creationId xmlns="" xmlns:a16="http://schemas.microsoft.com/office/drawing/2014/main" id="{A2341639-2B4B-4060-8627-F26FBC595A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79065" y="279971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63" name="CasellaDiTesto 162">
                      <a:extLst>
                        <a:ext uri="{FF2B5EF4-FFF2-40B4-BE49-F238E27FC236}">
                          <a16:creationId xmlns="" xmlns:a16="http://schemas.microsoft.com/office/drawing/2014/main" id="{2A2D4FBB-4A88-4AC6-ACBF-26DC2912B89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4880" y="277029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64" name="CasellaDiTesto 163">
                      <a:extLst>
                        <a:ext uri="{FF2B5EF4-FFF2-40B4-BE49-F238E27FC236}">
                          <a16:creationId xmlns="" xmlns:a16="http://schemas.microsoft.com/office/drawing/2014/main" id="{6EBCE0AC-4552-4F22-B8EC-819F01E48F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44932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65" name="CasellaDiTesto 164">
                      <a:extLst>
                        <a:ext uri="{FF2B5EF4-FFF2-40B4-BE49-F238E27FC236}">
                          <a16:creationId xmlns="" xmlns:a16="http://schemas.microsoft.com/office/drawing/2014/main" id="{64D2AA2D-5900-4D20-BF54-5C69178200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99539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66" name="CasellaDiTesto 165">
                      <a:extLst>
                        <a:ext uri="{FF2B5EF4-FFF2-40B4-BE49-F238E27FC236}">
                          <a16:creationId xmlns="" xmlns:a16="http://schemas.microsoft.com/office/drawing/2014/main" id="{E8EC2B3C-50F8-459B-9A9C-1478F4BB14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9763" y="2881414"/>
                      <a:ext cx="585969" cy="2545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17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S</a:t>
                      </a:r>
                    </a:p>
                  </p:txBody>
                </p:sp>
                <p:cxnSp>
                  <p:nvCxnSpPr>
                    <p:cNvPr id="167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28675" y="3051346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8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061023" y="3060000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69" name="Gruppo 168"/>
                <p:cNvGrpSpPr/>
                <p:nvPr/>
              </p:nvGrpSpPr>
              <p:grpSpPr>
                <a:xfrm>
                  <a:off x="4182365" y="2762994"/>
                  <a:ext cx="2749979" cy="638668"/>
                  <a:chOff x="1619763" y="2770297"/>
                  <a:chExt cx="2749979" cy="638668"/>
                </a:xfrm>
              </p:grpSpPr>
              <p:sp>
                <p:nvSpPr>
                  <p:cNvPr id="170" name="CasellaDiTesto 6">
                    <a:extLst>
                      <a:ext uri="{FF2B5EF4-FFF2-40B4-BE49-F238E27FC236}">
                        <a16:creationId xmlns="" xmlns:a16="http://schemas.microsoft.com/office/drawing/2014/main" id="{81EDA090-2EC6-4370-BCB0-C13F48BE519C}"/>
                      </a:ext>
                    </a:extLst>
                  </p:cNvPr>
                  <p:cNvSpPr txBox="1"/>
                  <p:nvPr/>
                </p:nvSpPr>
                <p:spPr>
                  <a:xfrm>
                    <a:off x="2095404" y="3092618"/>
                    <a:ext cx="1326854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dult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1" name="CasellaDiTesto 6">
                    <a:extLst>
                      <a:ext uri="{FF2B5EF4-FFF2-40B4-BE49-F238E27FC236}">
                        <a16:creationId xmlns="" xmlns:a16="http://schemas.microsoft.com/office/drawing/2014/main" id="{D38299FE-80FE-40EF-B4C1-1EA1D0FF2218}"/>
                      </a:ext>
                    </a:extLst>
                  </p:cNvPr>
                  <p:cNvSpPr txBox="1"/>
                  <p:nvPr/>
                </p:nvSpPr>
                <p:spPr>
                  <a:xfrm>
                    <a:off x="3176469" y="3092853"/>
                    <a:ext cx="1193273" cy="3161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284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ed</a:t>
                    </a:r>
                    <a:endParaRPr lang="en-GB" sz="1284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172" name="Gruppo 171"/>
                  <p:cNvGrpSpPr/>
                  <p:nvPr/>
                </p:nvGrpSpPr>
                <p:grpSpPr>
                  <a:xfrm>
                    <a:off x="1619763" y="2770297"/>
                    <a:ext cx="2229516" cy="365643"/>
                    <a:chOff x="1619763" y="2770297"/>
                    <a:chExt cx="2229516" cy="365643"/>
                  </a:xfrm>
                </p:grpSpPr>
                <p:sp>
                  <p:nvSpPr>
                    <p:cNvPr id="173" name="CasellaDiTesto 172">
                      <a:extLst>
                        <a:ext uri="{FF2B5EF4-FFF2-40B4-BE49-F238E27FC236}">
                          <a16:creationId xmlns="" xmlns:a16="http://schemas.microsoft.com/office/drawing/2014/main" id="{A2341639-2B4B-4060-8627-F26FBC595A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79065" y="279971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74" name="CasellaDiTesto 173">
                      <a:extLst>
                        <a:ext uri="{FF2B5EF4-FFF2-40B4-BE49-F238E27FC236}">
                          <a16:creationId xmlns="" xmlns:a16="http://schemas.microsoft.com/office/drawing/2014/main" id="{2A2D4FBB-4A88-4AC6-ACBF-26DC2912B89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4880" y="2770297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75" name="CasellaDiTesto 174">
                      <a:extLst>
                        <a:ext uri="{FF2B5EF4-FFF2-40B4-BE49-F238E27FC236}">
                          <a16:creationId xmlns="" xmlns:a16="http://schemas.microsoft.com/office/drawing/2014/main" id="{6EBCE0AC-4552-4F22-B8EC-819F01E48F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44932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-</a:t>
                      </a:r>
                    </a:p>
                  </p:txBody>
                </p:sp>
                <p:sp>
                  <p:nvSpPr>
                    <p:cNvPr id="176" name="CasellaDiTesto 175">
                      <a:extLst>
                        <a:ext uri="{FF2B5EF4-FFF2-40B4-BE49-F238E27FC236}">
                          <a16:creationId xmlns="" xmlns:a16="http://schemas.microsoft.com/office/drawing/2014/main" id="{64D2AA2D-5900-4D20-BF54-5C69178200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99539" y="2780044"/>
                      <a:ext cx="225784" cy="31611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84" dirty="0"/>
                        <a:t>+</a:t>
                      </a:r>
                    </a:p>
                  </p:txBody>
                </p:sp>
                <p:sp>
                  <p:nvSpPr>
                    <p:cNvPr id="177" name="CasellaDiTesto 176">
                      <a:extLst>
                        <a:ext uri="{FF2B5EF4-FFF2-40B4-BE49-F238E27FC236}">
                          <a16:creationId xmlns="" xmlns:a16="http://schemas.microsoft.com/office/drawing/2014/main" id="{E8EC2B3C-50F8-459B-9A9C-1478F4BB14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9763" y="2881414"/>
                      <a:ext cx="585969" cy="25452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17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S</a:t>
                      </a:r>
                    </a:p>
                  </p:txBody>
                </p:sp>
                <p:cxnSp>
                  <p:nvCxnSpPr>
                    <p:cNvPr id="178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28675" y="3051346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9" name="Connettore diritto 20">
                      <a:extLst>
                        <a:ext uri="{FF2B5EF4-FFF2-40B4-BE49-F238E27FC236}">
                          <a16:creationId xmlns="" xmlns:a16="http://schemas.microsoft.com/office/drawing/2014/main" id="{22696D9C-66EF-4433-B2E6-4D9CDE8FED0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061023" y="3060000"/>
                      <a:ext cx="720604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sp>
            <p:nvSpPr>
              <p:cNvPr id="181" name="CasellaDiTesto 180"/>
              <p:cNvSpPr txBox="1"/>
              <p:nvPr/>
            </p:nvSpPr>
            <p:spPr>
              <a:xfrm>
                <a:off x="1649013" y="3600876"/>
                <a:ext cx="158105" cy="3691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82" name="CasellaDiTesto 181"/>
              <p:cNvSpPr txBox="1"/>
              <p:nvPr/>
            </p:nvSpPr>
            <p:spPr>
              <a:xfrm>
                <a:off x="4364408" y="3605773"/>
                <a:ext cx="235266" cy="3691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183" name="CasellaDiTesto 182"/>
              <p:cNvSpPr txBox="1"/>
              <p:nvPr/>
            </p:nvSpPr>
            <p:spPr>
              <a:xfrm>
                <a:off x="1636984" y="6199718"/>
                <a:ext cx="158105" cy="3691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</a:p>
            </p:txBody>
          </p:sp>
          <p:sp>
            <p:nvSpPr>
              <p:cNvPr id="184" name="CasellaDiTesto 183"/>
              <p:cNvSpPr txBox="1"/>
              <p:nvPr/>
            </p:nvSpPr>
            <p:spPr>
              <a:xfrm>
                <a:off x="4352379" y="6204613"/>
                <a:ext cx="235266" cy="3691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</p:grpSp>
      </p:grpSp>
      <p:sp>
        <p:nvSpPr>
          <p:cNvPr id="186" name="Rettangolo 185"/>
          <p:cNvSpPr/>
          <p:nvPr/>
        </p:nvSpPr>
        <p:spPr>
          <a:xfrm>
            <a:off x="464095" y="8006101"/>
            <a:ext cx="570637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]-VC701 brain tracer uptake in cortex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-male; B-female); hippocampus (C-male; D-female) and cerebellum (E-male; F-female) on LPS-treated compared to vehicle adult and aged mice. Data were analyzed using parametric Unpaired Student T test of the brain uptake of LPS-treated mice compared to un-treated of each experimental group. Data are expressed as percentage (%) of injected dose per gram of tissue to blood ratio, mean ± SD, 8 mice per group; * p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,05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* 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&lt;0,01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** 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&lt;0,001;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5066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uppo 25">
            <a:extLst>
              <a:ext uri="{FF2B5EF4-FFF2-40B4-BE49-F238E27FC236}">
                <a16:creationId xmlns="" xmlns:a16="http://schemas.microsoft.com/office/drawing/2014/main" id="{B68FEFD3-21D3-4B43-B109-D92D60519BC9}"/>
              </a:ext>
            </a:extLst>
          </p:cNvPr>
          <p:cNvGrpSpPr/>
          <p:nvPr/>
        </p:nvGrpSpPr>
        <p:grpSpPr>
          <a:xfrm>
            <a:off x="572442" y="242654"/>
            <a:ext cx="5638574" cy="9203145"/>
            <a:chOff x="572442" y="242654"/>
            <a:chExt cx="5638574" cy="9203145"/>
          </a:xfrm>
        </p:grpSpPr>
        <p:graphicFrame>
          <p:nvGraphicFramePr>
            <p:cNvPr id="14" name="Oggetto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95287484"/>
                </p:ext>
              </p:extLst>
            </p:nvPr>
          </p:nvGraphicFramePr>
          <p:xfrm>
            <a:off x="648502" y="5975524"/>
            <a:ext cx="5518863" cy="3470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3" name="Prism 7" r:id="rId3" imgW="8758768" imgH="5415623" progId="Prism7.Document">
                    <p:embed/>
                  </p:oleObj>
                </mc:Choice>
                <mc:Fallback>
                  <p:oleObj name="Prism 7" r:id="rId3" imgW="8758768" imgH="5415623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48502" y="5975524"/>
                          <a:ext cx="5518863" cy="3470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ggetto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13526605"/>
                </p:ext>
              </p:extLst>
            </p:nvPr>
          </p:nvGraphicFramePr>
          <p:xfrm>
            <a:off x="692152" y="516274"/>
            <a:ext cx="5518864" cy="3581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4" name="Prism 7" r:id="rId5" imgW="9795076" imgH="5968884" progId="Prism7.Document">
                    <p:embed/>
                  </p:oleObj>
                </mc:Choice>
                <mc:Fallback>
                  <p:oleObj name="Prism 7" r:id="rId5" imgW="9795076" imgH="5968884" progId="Prism7.Document">
                    <p:embed/>
                    <p:pic>
                      <p:nvPicPr>
                        <p:cNvPr id="2" name="Oggetto 1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92152" y="516274"/>
                          <a:ext cx="5518864" cy="3581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CasellaDiTesto 2"/>
            <p:cNvSpPr txBox="1"/>
            <p:nvPr/>
          </p:nvSpPr>
          <p:spPr>
            <a:xfrm>
              <a:off x="839741" y="534876"/>
              <a:ext cx="763586" cy="279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1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1</a:t>
              </a:r>
              <a:r>
                <a:rPr lang="el-GR" sz="121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endParaRPr lang="it-IT" sz="121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CasellaDiTesto 3"/>
            <p:cNvSpPr txBox="1"/>
            <p:nvPr/>
          </p:nvSpPr>
          <p:spPr>
            <a:xfrm>
              <a:off x="855441" y="2399666"/>
              <a:ext cx="673536" cy="279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1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F-</a:t>
              </a:r>
              <a:r>
                <a:rPr lang="el-GR" sz="121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sz="121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848331" y="5801223"/>
              <a:ext cx="834296" cy="279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1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M2</a:t>
              </a:r>
              <a:endParaRPr lang="it-IT" sz="106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862427" y="7573495"/>
              <a:ext cx="982283" cy="279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1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M L2</a:t>
              </a: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595363" y="504044"/>
              <a:ext cx="25561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599823" y="2352730"/>
              <a:ext cx="25561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572442" y="5786543"/>
              <a:ext cx="25561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5" name="CasellaDiTesto 4"/>
            <p:cNvSpPr txBox="1"/>
            <p:nvPr/>
          </p:nvSpPr>
          <p:spPr>
            <a:xfrm>
              <a:off x="2404245" y="242654"/>
              <a:ext cx="20362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gure 2</a:t>
              </a:r>
            </a:p>
          </p:txBody>
        </p:sp>
        <p:graphicFrame>
          <p:nvGraphicFramePr>
            <p:cNvPr id="22" name="Oggetto 21">
              <a:extLst>
                <a:ext uri="{FF2B5EF4-FFF2-40B4-BE49-F238E27FC236}">
                  <a16:creationId xmlns="" xmlns:a16="http://schemas.microsoft.com/office/drawing/2014/main" id="{99255B95-1AA1-4544-9E50-B098BDFE85D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83333348"/>
                </p:ext>
              </p:extLst>
            </p:nvPr>
          </p:nvGraphicFramePr>
          <p:xfrm>
            <a:off x="683152" y="4246320"/>
            <a:ext cx="2399354" cy="155704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5" name="Prism 7" r:id="rId7" imgW="3853671" imgH="2503533" progId="Prism7.Document">
                    <p:embed/>
                  </p:oleObj>
                </mc:Choice>
                <mc:Fallback>
                  <p:oleObj name="Prism 7" r:id="rId7" imgW="3853671" imgH="2503533" progId="Prism7.Document">
                    <p:embed/>
                    <p:pic>
                      <p:nvPicPr>
                        <p:cNvPr id="2" name="Oggetto 1">
                          <a:extLst>
                            <a:ext uri="{FF2B5EF4-FFF2-40B4-BE49-F238E27FC236}">
                              <a16:creationId xmlns="" xmlns:a16="http://schemas.microsoft.com/office/drawing/2014/main" id="{8C274558-6D41-4B75-93FB-02BCD9A9911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83152" y="4246320"/>
                          <a:ext cx="2399354" cy="155704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Oggetto 22">
              <a:extLst>
                <a:ext uri="{FF2B5EF4-FFF2-40B4-BE49-F238E27FC236}">
                  <a16:creationId xmlns="" xmlns:a16="http://schemas.microsoft.com/office/drawing/2014/main" id="{7DC27E82-62A2-431A-84C0-C49991A0700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78649196"/>
                </p:ext>
              </p:extLst>
            </p:nvPr>
          </p:nvGraphicFramePr>
          <p:xfrm>
            <a:off x="3599034" y="4301021"/>
            <a:ext cx="2440264" cy="14476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46" name="Prism 7" r:id="rId9" imgW="3853671" imgH="2503533" progId="Prism7.Document">
                    <p:embed/>
                  </p:oleObj>
                </mc:Choice>
                <mc:Fallback>
                  <p:oleObj name="Prism 7" r:id="rId9" imgW="3853671" imgH="2503533" progId="Prism7.Document">
                    <p:embed/>
                    <p:pic>
                      <p:nvPicPr>
                        <p:cNvPr id="2" name="Oggetto 1">
                          <a:extLst>
                            <a:ext uri="{FF2B5EF4-FFF2-40B4-BE49-F238E27FC236}">
                              <a16:creationId xmlns="" xmlns:a16="http://schemas.microsoft.com/office/drawing/2014/main" id="{B79FF34C-CAB5-4960-ABE3-18165D8B39F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599034" y="4301021"/>
                          <a:ext cx="2440264" cy="14476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" name="CasellaDiTesto 23">
              <a:extLst>
                <a:ext uri="{FF2B5EF4-FFF2-40B4-BE49-F238E27FC236}">
                  <a16:creationId xmlns="" xmlns:a16="http://schemas.microsoft.com/office/drawing/2014/main" id="{7C1C15E8-7C97-4118-AC16-D494F1337974}"/>
                </a:ext>
              </a:extLst>
            </p:cNvPr>
            <p:cNvSpPr txBox="1"/>
            <p:nvPr/>
          </p:nvSpPr>
          <p:spPr>
            <a:xfrm>
              <a:off x="584634" y="7547219"/>
              <a:ext cx="255618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="" xmlns:a16="http://schemas.microsoft.com/office/drawing/2014/main" id="{424F4BDE-7514-4EB7-90B4-7931DA8331B0}"/>
                </a:ext>
              </a:extLst>
            </p:cNvPr>
            <p:cNvSpPr txBox="1"/>
            <p:nvPr/>
          </p:nvSpPr>
          <p:spPr>
            <a:xfrm>
              <a:off x="848331" y="4021073"/>
              <a:ext cx="6735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6</a:t>
              </a:r>
            </a:p>
          </p:txBody>
        </p:sp>
      </p:grpSp>
      <p:sp>
        <p:nvSpPr>
          <p:cNvPr id="18" name="CasellaDiTesto 17"/>
          <p:cNvSpPr txBox="1"/>
          <p:nvPr/>
        </p:nvSpPr>
        <p:spPr>
          <a:xfrm>
            <a:off x="584634" y="4032139"/>
            <a:ext cx="2556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84658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tangolo 2"/>
          <p:cNvSpPr/>
          <p:nvPr/>
        </p:nvSpPr>
        <p:spPr>
          <a:xfrm>
            <a:off x="444890" y="529441"/>
            <a:ext cx="5751373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2 Different expression levels of pro-inflammatory cytokines and different immunomodulatory mediators after peripheral insults in adult mice</a:t>
            </a: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analysis of Interleukin 1β (A), Tumor Necrosis Factor-α (B), IL-6 (C), TREM2 (D) and TREM L2(E) of ADULT LPS-treated and vehicle male and female animals by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in cortex, stratum, hippocampus and cerebellum. All the values were normalized to mouse β-actin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sing 2−ΔΔCT method and finally expressed as fold change. Bars represent the average of triplicate measurements and error bars represent ± SEM, 5 animals per groups. Statistical analysis was performed using parametric Unpaired Student T test of the relative mRNA expression of LPS-treated mice to internal control group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&lt;0,05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* 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&lt;0,01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** 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&lt;0,001;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01653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1083585"/>
              </p:ext>
            </p:extLst>
          </p:nvPr>
        </p:nvGraphicFramePr>
        <p:xfrm>
          <a:off x="568325" y="468313"/>
          <a:ext cx="5445125" cy="3509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5" name="Prism 7" r:id="rId4" imgW="8809161" imgH="6202139" progId="Prism7.Document">
                  <p:embed/>
                </p:oleObj>
              </mc:Choice>
              <mc:Fallback>
                <p:oleObj name="Prism 7" r:id="rId4" imgW="8809161" imgH="620213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8325" y="468313"/>
                        <a:ext cx="5445125" cy="3509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4464997"/>
              </p:ext>
            </p:extLst>
          </p:nvPr>
        </p:nvGraphicFramePr>
        <p:xfrm>
          <a:off x="629709" y="6001889"/>
          <a:ext cx="5435600" cy="3392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6" name="Prism 7" r:id="rId6" imgW="8702615" imgH="6093790" progId="Prism7.Document">
                  <p:embed/>
                </p:oleObj>
              </mc:Choice>
              <mc:Fallback>
                <p:oleObj name="Prism 7" r:id="rId6" imgW="8702615" imgH="6093790" progId="Prism7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29709" y="6001889"/>
                        <a:ext cx="5435600" cy="3392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CasellaDiTesto 23">
            <a:extLst>
              <a:ext uri="{FF2B5EF4-FFF2-40B4-BE49-F238E27FC236}">
                <a16:creationId xmlns="" xmlns:a16="http://schemas.microsoft.com/office/drawing/2014/main" id="{3CE0BCB3-FF5B-406E-AF29-5B0AC426CD2A}"/>
              </a:ext>
            </a:extLst>
          </p:cNvPr>
          <p:cNvSpPr txBox="1"/>
          <p:nvPr/>
        </p:nvSpPr>
        <p:spPr>
          <a:xfrm>
            <a:off x="759352" y="547233"/>
            <a:ext cx="763586" cy="279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19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1</a:t>
            </a:r>
            <a:r>
              <a:rPr lang="el-GR" sz="1219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it-IT" sz="121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CasellaDiTesto 25">
            <a:extLst>
              <a:ext uri="{FF2B5EF4-FFF2-40B4-BE49-F238E27FC236}">
                <a16:creationId xmlns="" xmlns:a16="http://schemas.microsoft.com/office/drawing/2014/main" id="{F8468863-E798-4D11-84B4-A90CACBBF07D}"/>
              </a:ext>
            </a:extLst>
          </p:cNvPr>
          <p:cNvSpPr txBox="1"/>
          <p:nvPr/>
        </p:nvSpPr>
        <p:spPr>
          <a:xfrm>
            <a:off x="750337" y="2399666"/>
            <a:ext cx="673536" cy="279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19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-</a:t>
            </a:r>
            <a:r>
              <a:rPr lang="el-GR" sz="1219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it-IT" sz="121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CasellaDiTesto 26">
            <a:extLst>
              <a:ext uri="{FF2B5EF4-FFF2-40B4-BE49-F238E27FC236}">
                <a16:creationId xmlns="" xmlns:a16="http://schemas.microsoft.com/office/drawing/2014/main" id="{25E8731A-46E8-4A22-85AE-D7651757A8FF}"/>
              </a:ext>
            </a:extLst>
          </p:cNvPr>
          <p:cNvSpPr txBox="1"/>
          <p:nvPr/>
        </p:nvSpPr>
        <p:spPr>
          <a:xfrm>
            <a:off x="764410" y="5811691"/>
            <a:ext cx="834296" cy="279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19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M2</a:t>
            </a:r>
            <a:endParaRPr lang="it-IT" sz="106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CasellaDiTesto 27">
            <a:extLst>
              <a:ext uri="{FF2B5EF4-FFF2-40B4-BE49-F238E27FC236}">
                <a16:creationId xmlns="" xmlns:a16="http://schemas.microsoft.com/office/drawing/2014/main" id="{3150B4F4-1662-48E0-AFAF-6A96AABFFBED}"/>
              </a:ext>
            </a:extLst>
          </p:cNvPr>
          <p:cNvSpPr txBox="1"/>
          <p:nvPr/>
        </p:nvSpPr>
        <p:spPr>
          <a:xfrm>
            <a:off x="759366" y="7667384"/>
            <a:ext cx="982283" cy="279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19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M L2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="" xmlns:a16="http://schemas.microsoft.com/office/drawing/2014/main" id="{63C73E97-DB47-4845-A785-2A21D42EF95F}"/>
              </a:ext>
            </a:extLst>
          </p:cNvPr>
          <p:cNvSpPr txBox="1"/>
          <p:nvPr/>
        </p:nvSpPr>
        <p:spPr>
          <a:xfrm>
            <a:off x="514974" y="516401"/>
            <a:ext cx="2556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="" xmlns:a16="http://schemas.microsoft.com/office/drawing/2014/main" id="{4E8A5AB5-9F08-46E0-B5EA-DD77FDC1FDF9}"/>
              </a:ext>
            </a:extLst>
          </p:cNvPr>
          <p:cNvSpPr txBox="1"/>
          <p:nvPr/>
        </p:nvSpPr>
        <p:spPr>
          <a:xfrm>
            <a:off x="494719" y="2352730"/>
            <a:ext cx="2556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="" xmlns:a16="http://schemas.microsoft.com/office/drawing/2014/main" id="{4C9397F9-563E-4A75-9484-2B573AFB140E}"/>
              </a:ext>
            </a:extLst>
          </p:cNvPr>
          <p:cNvSpPr txBox="1"/>
          <p:nvPr/>
        </p:nvSpPr>
        <p:spPr>
          <a:xfrm>
            <a:off x="474073" y="5772701"/>
            <a:ext cx="2556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="" xmlns:a16="http://schemas.microsoft.com/office/drawing/2014/main" id="{FA9477AC-EB81-4823-99D9-43D1EBA5BEA1}"/>
              </a:ext>
            </a:extLst>
          </p:cNvPr>
          <p:cNvSpPr txBox="1"/>
          <p:nvPr/>
        </p:nvSpPr>
        <p:spPr>
          <a:xfrm>
            <a:off x="468473" y="7615635"/>
            <a:ext cx="2556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="" xmlns:a16="http://schemas.microsoft.com/office/drawing/2014/main" id="{9C50BA3C-F5C9-4141-842F-72B51EA3C4CD}"/>
              </a:ext>
            </a:extLst>
          </p:cNvPr>
          <p:cNvSpPr txBox="1"/>
          <p:nvPr/>
        </p:nvSpPr>
        <p:spPr>
          <a:xfrm>
            <a:off x="2299141" y="242654"/>
            <a:ext cx="2036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</a:t>
            </a:r>
          </a:p>
        </p:txBody>
      </p:sp>
      <p:graphicFrame>
        <p:nvGraphicFramePr>
          <p:cNvPr id="17" name="Oggetto 16">
            <a:extLst>
              <a:ext uri="{FF2B5EF4-FFF2-40B4-BE49-F238E27FC236}">
                <a16:creationId xmlns="" xmlns:a16="http://schemas.microsoft.com/office/drawing/2014/main" id="{4243B7A1-1F35-4B5D-86A3-281296991D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1902448"/>
              </p:ext>
            </p:extLst>
          </p:nvPr>
        </p:nvGraphicFramePr>
        <p:xfrm>
          <a:off x="645565" y="4350565"/>
          <a:ext cx="2321357" cy="14048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7" name="Prism 7" r:id="rId8" imgW="3827754" imgH="2400224" progId="Prism7.Document">
                  <p:embed/>
                </p:oleObj>
              </mc:Choice>
              <mc:Fallback>
                <p:oleObj name="Prism 7" r:id="rId8" imgW="3827754" imgH="2400224" progId="Prism7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="" xmlns:a16="http://schemas.microsoft.com/office/drawing/2014/main" id="{A3232C39-F116-47FF-AC1C-CFCABCE2E6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45565" y="4350565"/>
                        <a:ext cx="2321357" cy="14048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ggetto 17">
            <a:extLst>
              <a:ext uri="{FF2B5EF4-FFF2-40B4-BE49-F238E27FC236}">
                <a16:creationId xmlns="" xmlns:a16="http://schemas.microsoft.com/office/drawing/2014/main" id="{228ED303-5C3D-4229-A814-39C08D6FCB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4678867"/>
              </p:ext>
            </p:extLst>
          </p:nvPr>
        </p:nvGraphicFramePr>
        <p:xfrm>
          <a:off x="3511038" y="4332064"/>
          <a:ext cx="2426342" cy="14577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8" name="Prism 7" r:id="rId10" imgW="3827754" imgH="2400224" progId="Prism7.Document">
                  <p:embed/>
                </p:oleObj>
              </mc:Choice>
              <mc:Fallback>
                <p:oleObj name="Prism 7" r:id="rId10" imgW="3827754" imgH="2400224" progId="Prism7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="" xmlns:a16="http://schemas.microsoft.com/office/drawing/2014/main" id="{69CD9191-466D-4460-BBC3-5A7B1B1614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511038" y="4332064"/>
                        <a:ext cx="2426342" cy="14577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CasellaDiTesto 20"/>
          <p:cNvSpPr txBox="1"/>
          <p:nvPr/>
        </p:nvSpPr>
        <p:spPr>
          <a:xfrm>
            <a:off x="513074" y="4032139"/>
            <a:ext cx="255618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="" xmlns:a16="http://schemas.microsoft.com/office/drawing/2014/main" id="{F8468863-E798-4D11-84B4-A90CACBBF07D}"/>
              </a:ext>
            </a:extLst>
          </p:cNvPr>
          <p:cNvSpPr txBox="1"/>
          <p:nvPr/>
        </p:nvSpPr>
        <p:spPr>
          <a:xfrm>
            <a:off x="769282" y="4061442"/>
            <a:ext cx="673536" cy="279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19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6</a:t>
            </a:r>
            <a:endParaRPr lang="it-IT" sz="121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4110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tangolo 2"/>
          <p:cNvSpPr/>
          <p:nvPr/>
        </p:nvSpPr>
        <p:spPr>
          <a:xfrm>
            <a:off x="560288" y="705625"/>
            <a:ext cx="5690484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3 Different expression levels of pro-inflammatory cytokines and different immunomodulatory mediators after peripheral insults in aged mice</a:t>
            </a: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analysis of Interleukin 1β (A), Tumor Necrosis Factor-α (B), IL-6 (C), TREM2 (D) and TREM L2(E) of AGED LPS-treated and vehicle male and female animals by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in cortex, stratum, hippocampus and cerebellum. All the values were normalized to mouse β-actin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sing 2−ΔΔCT method and finally expressed as fold change. Bars represent the average of triplicate measurements and error bars represent ± SEM, 5 animals per groups. Statistical analysis was performed using parametric Unpaired Student T test of the relative mRNA expression of LPS-treated mice to internal control group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 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&lt;0,05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* 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&lt;0,01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*** 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&lt;0,001;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96606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4</TotalTime>
  <Words>469</Words>
  <Application>Microsoft Office PowerPoint</Application>
  <PresentationFormat>A4 (21x29,7 cm)</PresentationFormat>
  <Paragraphs>91</Paragraphs>
  <Slides>5</Slides>
  <Notes>2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2</vt:i4>
      </vt:variant>
      <vt:variant>
        <vt:lpstr>Titoli diapositive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ema di Office</vt:lpstr>
      <vt:lpstr>Prism 6</vt:lpstr>
      <vt:lpstr>Prism 7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urtaj Valentina</dc:creator>
  <cp:lastModifiedBy>valentina.murtaj@unimib.it</cp:lastModifiedBy>
  <cp:revision>87</cp:revision>
  <cp:lastPrinted>2019-06-22T09:49:48Z</cp:lastPrinted>
  <dcterms:created xsi:type="dcterms:W3CDTF">2018-10-06T18:01:51Z</dcterms:created>
  <dcterms:modified xsi:type="dcterms:W3CDTF">2019-10-23T13:17:00Z</dcterms:modified>
</cp:coreProperties>
</file>